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sldIdLst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30"/>
    <p:restoredTop sz="95814"/>
  </p:normalViewPr>
  <p:slideViewPr>
    <p:cSldViewPr snapToGrid="0" snapToObjects="1">
      <p:cViewPr varScale="1">
        <p:scale>
          <a:sx n="120" d="100"/>
          <a:sy n="120" d="100"/>
        </p:scale>
        <p:origin x="114" y="2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2" Type="http://schemas.openxmlformats.org/officeDocument/2006/relationships/customXml" Target="../customXml/item2.xml"/><Relationship Id="rId16" Type="http://schemas.openxmlformats.org/officeDocument/2006/relationships/tableStyles" Target="tableStyle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theme" Target="theme/theme1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B83B86-C07F-4842-BB08-943E507D530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5ED2FDA-859E-E645-AC2D-C512D6528F5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9B98EE-2BCD-E943-A1E2-AE6A049443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ABC8B-CE6D-5B4B-B635-9A2239B93FCB}" type="datetimeFigureOut">
              <a:rPr lang="en-US" smtClean="0"/>
              <a:t>10/2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7BC248-52DC-4E4A-A7B3-37BE66538E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BEDAFF-99FA-224F-A713-6FAC9EC9C1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8A77B-03FE-A745-A9ED-0651AF71C6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06342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9BC230-C15F-9549-B239-68AFDDFAF6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B36768A-4D56-A645-8DCB-320346884E6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83A884-D40D-6342-938A-FFD90DEE76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ABC8B-CE6D-5B4B-B635-9A2239B93FCB}" type="datetimeFigureOut">
              <a:rPr lang="en-US" smtClean="0"/>
              <a:t>10/2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7ABE86-3E3F-3242-966A-EBAFE58BD5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8F8E1B-E0D5-CE4C-9763-14CEEC2529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8A77B-03FE-A745-A9ED-0651AF71C6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00727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436478F-AC96-8146-B595-3420DB4664E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4D685B7-1B48-EB4C-9977-657B50D9DDB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AFF9B9-E5D2-E74A-A53E-A3010D6BE5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ABC8B-CE6D-5B4B-B635-9A2239B93FCB}" type="datetimeFigureOut">
              <a:rPr lang="en-US" smtClean="0"/>
              <a:t>10/2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B3B300-50FA-2A46-A257-352B1D06B6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2CE8B4-FAA7-8D4B-8B1B-D6D40CA43D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8A77B-03FE-A745-A9ED-0651AF71C6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8591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7E172C-A45B-014C-902C-E1B2A0768C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373F3E6-25C2-7041-AB48-0DD12761DE8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89B8FB-08DA-1044-ABF3-09BA91230B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ABC8B-CE6D-5B4B-B635-9A2239B93FCB}" type="datetimeFigureOut">
              <a:rPr lang="en-US" smtClean="0"/>
              <a:t>10/2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4EFF36-8FB8-CE49-BA63-355D249544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9AF5C6-C98B-C748-A1F6-1C3C5AA8E7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8A77B-03FE-A745-A9ED-0651AF71C6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30613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099D22-6D35-B849-8D12-C8B097DD5F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ECB10F1-E5CF-4346-9729-EDEB16A8F9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D4025F-95BE-D04C-9F7C-B7DF7E5810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ABC8B-CE6D-5B4B-B635-9A2239B93FCB}" type="datetimeFigureOut">
              <a:rPr lang="en-US" smtClean="0"/>
              <a:t>10/2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367C5D-223C-AB40-B666-5DD55F54CB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259E9B-EBE2-D846-933E-6E51F0EAEC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8A77B-03FE-A745-A9ED-0651AF71C6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74409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8C7BDE-A159-4B44-B44E-169558F32D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68E61CA-8C49-D14D-94B8-2AB438AF9E0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22C6086-4165-644C-9413-B68FC8C64F6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F2C606E-BA97-8F48-BE47-5B50C30BB9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ABC8B-CE6D-5B4B-B635-9A2239B93FCB}" type="datetimeFigureOut">
              <a:rPr lang="en-US" smtClean="0"/>
              <a:t>10/2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29EAF70-4BDB-6A4F-9ACB-C77FDF0569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D757948-1CC0-9041-9884-9DFC591065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8A77B-03FE-A745-A9ED-0651AF71C6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4858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22E774-1D70-7946-A076-8006C4A56F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EEE5394-4A95-5643-BA8B-D713E08925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685CBAA-7EB0-3449-8CB0-A520E5CBA6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5EAAED8-3824-DC47-9BD3-C93F2B12AB5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1FF6C64-FD3E-204D-96D0-22B52307A6A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CEF0E80-2239-214D-9988-24E682DCB5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ABC8B-CE6D-5B4B-B635-9A2239B93FCB}" type="datetimeFigureOut">
              <a:rPr lang="en-US" smtClean="0"/>
              <a:t>10/22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A1C07AB-0CFA-4C48-9693-1C0CCAA629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23B1F3D-347F-F34B-8517-FB1A004B83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8A77B-03FE-A745-A9ED-0651AF71C6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56988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C15AA7-A919-2C4A-88A2-18D3377640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BF5C9A4-3B98-A94D-910A-D42EE99A89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ABC8B-CE6D-5B4B-B635-9A2239B93FCB}" type="datetimeFigureOut">
              <a:rPr lang="en-US" smtClean="0"/>
              <a:t>10/22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48E7CE2-5D08-C247-8852-85320F01FD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DA8EACE-A215-4845-BA0B-A19D358366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8A77B-03FE-A745-A9ED-0651AF71C6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38510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D6A530F-A23F-154E-B894-12530D4751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ABC8B-CE6D-5B4B-B635-9A2239B93FCB}" type="datetimeFigureOut">
              <a:rPr lang="en-US" smtClean="0"/>
              <a:t>10/22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8DA2227-ACCB-C840-ACFE-7067339897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0516689-AD75-9041-AE62-AE880A202B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8A77B-03FE-A745-A9ED-0651AF71C6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10141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301F8A-D5FC-6F40-8D2C-385DBB55D7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423AC5C-8AC5-764E-B86B-7A04E0B751B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0293DF0-0115-1946-A918-6689D24342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76E2821-44CA-9440-83D4-990899CF19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ABC8B-CE6D-5B4B-B635-9A2239B93FCB}" type="datetimeFigureOut">
              <a:rPr lang="en-US" smtClean="0"/>
              <a:t>10/2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2255CA0-E1D7-2347-8B50-C3E60427A7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2EEE556-E331-A841-90E4-74618FC7C0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8A77B-03FE-A745-A9ED-0651AF71C6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18779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614BB7-74BA-B04E-ADD9-C68F699780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F648659-3E2D-284A-BCB4-A1C0FCF4767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3812BEC-02B1-3244-92E1-D163D6DE25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9BECFDF-C472-5C44-A89B-1FFE211BAC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ABC8B-CE6D-5B4B-B635-9A2239B93FCB}" type="datetimeFigureOut">
              <a:rPr lang="en-US" smtClean="0"/>
              <a:t>10/2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C37045-F12B-BF4B-AE21-D39E5FE770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05C650-62F8-294F-A82E-AE16D8DC89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8A77B-03FE-A745-A9ED-0651AF71C6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35983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60D4C36-FA2F-D444-937A-318D20D28C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25A4461-D81D-B24D-A7EC-615DC397A5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BDC3C7-CCD9-B240-97E2-0501B963548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3ABC8B-CE6D-5B4B-B635-9A2239B93FCB}" type="datetimeFigureOut">
              <a:rPr lang="en-US" smtClean="0"/>
              <a:t>10/2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3CFCF1-306A-D440-8C39-02D5B006449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207582-10F0-1C4B-BD02-FF97DDE7B73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18A77B-03FE-A745-A9ED-0651AF71C6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30054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6.tiff"/><Relationship Id="rId4" Type="http://schemas.openxmlformats.org/officeDocument/2006/relationships/image" Target="../media/image5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0.tiff"/><Relationship Id="rId4" Type="http://schemas.openxmlformats.org/officeDocument/2006/relationships/image" Target="../media/image9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f"/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4.tiff"/><Relationship Id="rId4" Type="http://schemas.openxmlformats.org/officeDocument/2006/relationships/image" Target="../media/image13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f"/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8.tiff"/><Relationship Id="rId4" Type="http://schemas.openxmlformats.org/officeDocument/2006/relationships/image" Target="../media/image17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tiff"/><Relationship Id="rId2" Type="http://schemas.openxmlformats.org/officeDocument/2006/relationships/image" Target="../media/image19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2.tiff"/><Relationship Id="rId4" Type="http://schemas.openxmlformats.org/officeDocument/2006/relationships/image" Target="../media/image21.tif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tiff"/><Relationship Id="rId2" Type="http://schemas.openxmlformats.org/officeDocument/2006/relationships/image" Target="../media/image23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6.tiff"/><Relationship Id="rId4" Type="http://schemas.openxmlformats.org/officeDocument/2006/relationships/image" Target="../media/image2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F8BD83-931F-E144-B9DE-7C674F6B90B1}"/>
              </a:ext>
            </a:extLst>
          </p:cNvPr>
          <p:cNvSpPr txBox="1"/>
          <p:nvPr/>
        </p:nvSpPr>
        <p:spPr>
          <a:xfrm>
            <a:off x="632494" y="1172736"/>
            <a:ext cx="7360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Set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0E46386-1021-9A45-965A-D8F78A7CF4CC}"/>
              </a:ext>
            </a:extLst>
          </p:cNvPr>
          <p:cNvSpPr txBox="1"/>
          <p:nvPr/>
        </p:nvSpPr>
        <p:spPr>
          <a:xfrm>
            <a:off x="6789411" y="598275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14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5BE0B7D-8381-114E-9D3C-6DD0EBA47928}"/>
              </a:ext>
            </a:extLst>
          </p:cNvPr>
          <p:cNvSpPr txBox="1"/>
          <p:nvPr/>
        </p:nvSpPr>
        <p:spPr>
          <a:xfrm>
            <a:off x="5517216" y="5982752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lasmid#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25C9830D-339D-2140-B7CD-A7DA8B9FFF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77792899"/>
              </p:ext>
            </p:extLst>
          </p:nvPr>
        </p:nvGraphicFramePr>
        <p:xfrm>
          <a:off x="3794555" y="1418970"/>
          <a:ext cx="6476561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55185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333578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380131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359341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333954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373712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405516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326004">
                  <a:extLst>
                    <a:ext uri="{9D8B030D-6E8A-4147-A177-3AD203B41FA5}">
                      <a16:colId xmlns:a16="http://schemas.microsoft.com/office/drawing/2014/main" val="148875133"/>
                    </a:ext>
                  </a:extLst>
                </a:gridCol>
                <a:gridCol w="357808">
                  <a:extLst>
                    <a:ext uri="{9D8B030D-6E8A-4147-A177-3AD203B41FA5}">
                      <a16:colId xmlns:a16="http://schemas.microsoft.com/office/drawing/2014/main" val="1233904705"/>
                    </a:ext>
                  </a:extLst>
                </a:gridCol>
                <a:gridCol w="373712">
                  <a:extLst>
                    <a:ext uri="{9D8B030D-6E8A-4147-A177-3AD203B41FA5}">
                      <a16:colId xmlns:a16="http://schemas.microsoft.com/office/drawing/2014/main" val="3656884100"/>
                    </a:ext>
                  </a:extLst>
                </a:gridCol>
                <a:gridCol w="302149">
                  <a:extLst>
                    <a:ext uri="{9D8B030D-6E8A-4147-A177-3AD203B41FA5}">
                      <a16:colId xmlns:a16="http://schemas.microsoft.com/office/drawing/2014/main" val="2509758925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1113358615"/>
                    </a:ext>
                  </a:extLst>
                </a:gridCol>
                <a:gridCol w="508818">
                  <a:extLst>
                    <a:ext uri="{9D8B030D-6E8A-4147-A177-3AD203B41FA5}">
                      <a16:colId xmlns:a16="http://schemas.microsoft.com/office/drawing/2014/main" val="2422224856"/>
                    </a:ext>
                  </a:extLst>
                </a:gridCol>
                <a:gridCol w="290945">
                  <a:extLst>
                    <a:ext uri="{9D8B030D-6E8A-4147-A177-3AD203B41FA5}">
                      <a16:colId xmlns:a16="http://schemas.microsoft.com/office/drawing/2014/main" val="1253338770"/>
                    </a:ext>
                  </a:extLst>
                </a:gridCol>
                <a:gridCol w="346364">
                  <a:extLst>
                    <a:ext uri="{9D8B030D-6E8A-4147-A177-3AD203B41FA5}">
                      <a16:colId xmlns:a16="http://schemas.microsoft.com/office/drawing/2014/main" val="2419459170"/>
                    </a:ext>
                  </a:extLst>
                </a:gridCol>
                <a:gridCol w="863584">
                  <a:extLst>
                    <a:ext uri="{9D8B030D-6E8A-4147-A177-3AD203B41FA5}">
                      <a16:colId xmlns:a16="http://schemas.microsoft.com/office/drawing/2014/main" val="405931063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800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r>
                        <a:rPr lang="en-US" sz="1800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83DE2251-F7E1-3E42-B923-8EB624AE6126}"/>
              </a:ext>
            </a:extLst>
          </p:cNvPr>
          <p:cNvSpPr/>
          <p:nvPr/>
        </p:nvSpPr>
        <p:spPr>
          <a:xfrm>
            <a:off x="5495278" y="485303"/>
            <a:ext cx="175554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/>
              <a:t>Negative Control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0B1C1C5-BFF8-FF4D-8A0E-24B06406C54B}"/>
              </a:ext>
            </a:extLst>
          </p:cNvPr>
          <p:cNvCxnSpPr>
            <a:cxnSpLocks/>
          </p:cNvCxnSpPr>
          <p:nvPr/>
        </p:nvCxnSpPr>
        <p:spPr>
          <a:xfrm>
            <a:off x="4212928" y="883815"/>
            <a:ext cx="4320246" cy="151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8C9592F-49D7-0844-99C2-8DB7C7D943FF}"/>
              </a:ext>
            </a:extLst>
          </p:cNvPr>
          <p:cNvSpPr txBox="1"/>
          <p:nvPr/>
        </p:nvSpPr>
        <p:spPr>
          <a:xfrm>
            <a:off x="5415466" y="854328"/>
            <a:ext cx="22418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Cys</a:t>
            </a:r>
            <a:r>
              <a:rPr lang="en-US" dirty="0"/>
              <a:t>-less 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737BF3F-6EE7-7A48-85B4-D3C35E84D4BD}"/>
              </a:ext>
            </a:extLst>
          </p:cNvPr>
          <p:cNvCxnSpPr>
            <a:cxnSpLocks/>
          </p:cNvCxnSpPr>
          <p:nvPr/>
        </p:nvCxnSpPr>
        <p:spPr>
          <a:xfrm>
            <a:off x="4187369" y="1153963"/>
            <a:ext cx="4345805" cy="89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DADAD4B-A451-BF44-9398-55F086826971}"/>
              </a:ext>
            </a:extLst>
          </p:cNvPr>
          <p:cNvSpPr txBox="1"/>
          <p:nvPr/>
        </p:nvSpPr>
        <p:spPr>
          <a:xfrm>
            <a:off x="4433746" y="1148029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5 min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FE3AA2A-12E4-264D-A90B-64D156CF03CF}"/>
              </a:ext>
            </a:extLst>
          </p:cNvPr>
          <p:cNvCxnSpPr>
            <a:cxnSpLocks/>
          </p:cNvCxnSpPr>
          <p:nvPr/>
        </p:nvCxnSpPr>
        <p:spPr>
          <a:xfrm>
            <a:off x="5362670" y="1160379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A92A573A-4C4F-D440-AC61-E15E2828EC10}"/>
              </a:ext>
            </a:extLst>
          </p:cNvPr>
          <p:cNvCxnSpPr>
            <a:cxnSpLocks/>
          </p:cNvCxnSpPr>
          <p:nvPr/>
        </p:nvCxnSpPr>
        <p:spPr>
          <a:xfrm>
            <a:off x="6473580" y="1179142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DC9ABD0A-8C17-B94D-A3A8-C1A0FC5FA95A}"/>
              </a:ext>
            </a:extLst>
          </p:cNvPr>
          <p:cNvCxnSpPr>
            <a:cxnSpLocks/>
          </p:cNvCxnSpPr>
          <p:nvPr/>
        </p:nvCxnSpPr>
        <p:spPr>
          <a:xfrm>
            <a:off x="7562670" y="1153217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4AE5154D-8589-134C-9585-E38585188821}"/>
              </a:ext>
            </a:extLst>
          </p:cNvPr>
          <p:cNvSpPr txBox="1"/>
          <p:nvPr/>
        </p:nvSpPr>
        <p:spPr>
          <a:xfrm>
            <a:off x="5518026" y="1148029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0 min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0DC14FA-5251-6E41-90A4-35C6A953FEE7}"/>
              </a:ext>
            </a:extLst>
          </p:cNvPr>
          <p:cNvSpPr txBox="1"/>
          <p:nvPr/>
        </p:nvSpPr>
        <p:spPr>
          <a:xfrm>
            <a:off x="6608846" y="1161443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5 min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7618933-C90E-E54D-8F81-C272538A86F3}"/>
              </a:ext>
            </a:extLst>
          </p:cNvPr>
          <p:cNvSpPr txBox="1"/>
          <p:nvPr/>
        </p:nvSpPr>
        <p:spPr>
          <a:xfrm>
            <a:off x="7666205" y="1172736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0 min</a:t>
            </a: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1CE3BB52-3627-0E44-AE04-A9864AACB996}"/>
              </a:ext>
            </a:extLst>
          </p:cNvPr>
          <p:cNvSpPr/>
          <p:nvPr/>
        </p:nvSpPr>
        <p:spPr>
          <a:xfrm>
            <a:off x="3336940" y="3689370"/>
            <a:ext cx="796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</a:t>
            </a:r>
            <a:r>
              <a:rPr lang="en-US" dirty="0">
                <a:solidFill>
                  <a:prstClr val="black"/>
                </a:solidFill>
                <a:cs typeface="Arial" panose="020B0604020202020204" pitchFamily="34" charset="0"/>
              </a:rPr>
              <a:t>FLAG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EFB319C-01FB-CF45-B370-A688D5811BFC}"/>
              </a:ext>
            </a:extLst>
          </p:cNvPr>
          <p:cNvSpPr txBox="1"/>
          <p:nvPr/>
        </p:nvSpPr>
        <p:spPr>
          <a:xfrm>
            <a:off x="8967591" y="4368282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2D0DA33-455E-C74C-A4FE-3F9B5D705F35}"/>
              </a:ext>
            </a:extLst>
          </p:cNvPr>
          <p:cNvCxnSpPr>
            <a:cxnSpLocks/>
          </p:cNvCxnSpPr>
          <p:nvPr/>
        </p:nvCxnSpPr>
        <p:spPr>
          <a:xfrm flipH="1">
            <a:off x="8735119" y="4563711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3C37B689-6B36-1740-81D0-715391613210}"/>
              </a:ext>
            </a:extLst>
          </p:cNvPr>
          <p:cNvCxnSpPr>
            <a:cxnSpLocks/>
          </p:cNvCxnSpPr>
          <p:nvPr/>
        </p:nvCxnSpPr>
        <p:spPr>
          <a:xfrm flipH="1">
            <a:off x="8741913" y="5264511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DB45A5D7-91CB-204C-A340-B265AAA3482A}"/>
              </a:ext>
            </a:extLst>
          </p:cNvPr>
          <p:cNvSpPr/>
          <p:nvPr/>
        </p:nvSpPr>
        <p:spPr>
          <a:xfrm>
            <a:off x="8967591" y="3655793"/>
            <a:ext cx="23628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ytTM-SpoIVFB dimer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C112A1D-8ADD-B74C-9F34-D182455DA6B6}"/>
              </a:ext>
            </a:extLst>
          </p:cNvPr>
          <p:cNvCxnSpPr>
            <a:cxnSpLocks/>
          </p:cNvCxnSpPr>
          <p:nvPr/>
        </p:nvCxnSpPr>
        <p:spPr>
          <a:xfrm flipH="1">
            <a:off x="8747413" y="3841861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ECB1A0D-6AAD-FD49-AEFF-54C7A587AF7B}"/>
              </a:ext>
            </a:extLst>
          </p:cNvPr>
          <p:cNvSpPr txBox="1"/>
          <p:nvPr/>
        </p:nvSpPr>
        <p:spPr>
          <a:xfrm>
            <a:off x="8967591" y="5066594"/>
            <a:ext cx="2362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tTM-SpoIVFB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491F8F5-82D5-3E43-A3DF-7781543EFDD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43978" y="2134652"/>
            <a:ext cx="4470400" cy="384810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6095385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F8BD83-931F-E144-B9DE-7C674F6B90B1}"/>
              </a:ext>
            </a:extLst>
          </p:cNvPr>
          <p:cNvSpPr txBox="1"/>
          <p:nvPr/>
        </p:nvSpPr>
        <p:spPr>
          <a:xfrm>
            <a:off x="632494" y="1172736"/>
            <a:ext cx="7360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Set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0E46386-1021-9A45-965A-D8F78A7CF4CC}"/>
              </a:ext>
            </a:extLst>
          </p:cNvPr>
          <p:cNvSpPr txBox="1"/>
          <p:nvPr/>
        </p:nvSpPr>
        <p:spPr>
          <a:xfrm>
            <a:off x="6789411" y="598275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14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5BE0B7D-8381-114E-9D3C-6DD0EBA47928}"/>
              </a:ext>
            </a:extLst>
          </p:cNvPr>
          <p:cNvSpPr txBox="1"/>
          <p:nvPr/>
        </p:nvSpPr>
        <p:spPr>
          <a:xfrm>
            <a:off x="5517216" y="5982752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lasmid#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25C9830D-339D-2140-B7CD-A7DA8B9FFF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6245309"/>
              </p:ext>
            </p:extLst>
          </p:nvPr>
        </p:nvGraphicFramePr>
        <p:xfrm>
          <a:off x="3818405" y="1425979"/>
          <a:ext cx="6682746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55185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304589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409120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319588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357809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349857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389614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286247">
                  <a:extLst>
                    <a:ext uri="{9D8B030D-6E8A-4147-A177-3AD203B41FA5}">
                      <a16:colId xmlns:a16="http://schemas.microsoft.com/office/drawing/2014/main" val="148875133"/>
                    </a:ext>
                  </a:extLst>
                </a:gridCol>
                <a:gridCol w="333955">
                  <a:extLst>
                    <a:ext uri="{9D8B030D-6E8A-4147-A177-3AD203B41FA5}">
                      <a16:colId xmlns:a16="http://schemas.microsoft.com/office/drawing/2014/main" val="1233904705"/>
                    </a:ext>
                  </a:extLst>
                </a:gridCol>
                <a:gridCol w="429370">
                  <a:extLst>
                    <a:ext uri="{9D8B030D-6E8A-4147-A177-3AD203B41FA5}">
                      <a16:colId xmlns:a16="http://schemas.microsoft.com/office/drawing/2014/main" val="3656884100"/>
                    </a:ext>
                  </a:extLst>
                </a:gridCol>
                <a:gridCol w="278296">
                  <a:extLst>
                    <a:ext uri="{9D8B030D-6E8A-4147-A177-3AD203B41FA5}">
                      <a16:colId xmlns:a16="http://schemas.microsoft.com/office/drawing/2014/main" val="2509758925"/>
                    </a:ext>
                  </a:extLst>
                </a:gridCol>
                <a:gridCol w="326003">
                  <a:extLst>
                    <a:ext uri="{9D8B030D-6E8A-4147-A177-3AD203B41FA5}">
                      <a16:colId xmlns:a16="http://schemas.microsoft.com/office/drawing/2014/main" val="1113358615"/>
                    </a:ext>
                  </a:extLst>
                </a:gridCol>
                <a:gridCol w="842220">
                  <a:extLst>
                    <a:ext uri="{9D8B030D-6E8A-4147-A177-3AD203B41FA5}">
                      <a16:colId xmlns:a16="http://schemas.microsoft.com/office/drawing/2014/main" val="2422224856"/>
                    </a:ext>
                  </a:extLst>
                </a:gridCol>
                <a:gridCol w="290945">
                  <a:extLst>
                    <a:ext uri="{9D8B030D-6E8A-4147-A177-3AD203B41FA5}">
                      <a16:colId xmlns:a16="http://schemas.microsoft.com/office/drawing/2014/main" val="1253338770"/>
                    </a:ext>
                  </a:extLst>
                </a:gridCol>
                <a:gridCol w="346364">
                  <a:extLst>
                    <a:ext uri="{9D8B030D-6E8A-4147-A177-3AD203B41FA5}">
                      <a16:colId xmlns:a16="http://schemas.microsoft.com/office/drawing/2014/main" val="2419459170"/>
                    </a:ext>
                  </a:extLst>
                </a:gridCol>
                <a:gridCol w="863584">
                  <a:extLst>
                    <a:ext uri="{9D8B030D-6E8A-4147-A177-3AD203B41FA5}">
                      <a16:colId xmlns:a16="http://schemas.microsoft.com/office/drawing/2014/main" val="405931063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800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r>
                        <a:rPr lang="en-US" sz="1800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83DE2251-F7E1-3E42-B923-8EB624AE6126}"/>
              </a:ext>
            </a:extLst>
          </p:cNvPr>
          <p:cNvSpPr/>
          <p:nvPr/>
        </p:nvSpPr>
        <p:spPr>
          <a:xfrm>
            <a:off x="5495278" y="485303"/>
            <a:ext cx="175554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/>
              <a:t>Negative Control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0B1C1C5-BFF8-FF4D-8A0E-24B06406C54B}"/>
              </a:ext>
            </a:extLst>
          </p:cNvPr>
          <p:cNvCxnSpPr>
            <a:cxnSpLocks/>
          </p:cNvCxnSpPr>
          <p:nvPr/>
        </p:nvCxnSpPr>
        <p:spPr>
          <a:xfrm>
            <a:off x="4212928" y="883815"/>
            <a:ext cx="4320246" cy="151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8C9592F-49D7-0844-99C2-8DB7C7D943FF}"/>
              </a:ext>
            </a:extLst>
          </p:cNvPr>
          <p:cNvSpPr txBox="1"/>
          <p:nvPr/>
        </p:nvSpPr>
        <p:spPr>
          <a:xfrm>
            <a:off x="5415466" y="854328"/>
            <a:ext cx="22418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Cys</a:t>
            </a:r>
            <a:r>
              <a:rPr lang="en-US" dirty="0"/>
              <a:t>-less 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737BF3F-6EE7-7A48-85B4-D3C35E84D4BD}"/>
              </a:ext>
            </a:extLst>
          </p:cNvPr>
          <p:cNvCxnSpPr>
            <a:cxnSpLocks/>
          </p:cNvCxnSpPr>
          <p:nvPr/>
        </p:nvCxnSpPr>
        <p:spPr>
          <a:xfrm>
            <a:off x="4187369" y="1153963"/>
            <a:ext cx="4345805" cy="89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DADAD4B-A451-BF44-9398-55F086826971}"/>
              </a:ext>
            </a:extLst>
          </p:cNvPr>
          <p:cNvSpPr txBox="1"/>
          <p:nvPr/>
        </p:nvSpPr>
        <p:spPr>
          <a:xfrm>
            <a:off x="4425795" y="1148029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5 min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FE3AA2A-12E4-264D-A90B-64D156CF03CF}"/>
              </a:ext>
            </a:extLst>
          </p:cNvPr>
          <p:cNvCxnSpPr>
            <a:cxnSpLocks/>
          </p:cNvCxnSpPr>
          <p:nvPr/>
        </p:nvCxnSpPr>
        <p:spPr>
          <a:xfrm>
            <a:off x="5362670" y="1160379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A92A573A-4C4F-D440-AC61-E15E2828EC10}"/>
              </a:ext>
            </a:extLst>
          </p:cNvPr>
          <p:cNvCxnSpPr>
            <a:cxnSpLocks/>
          </p:cNvCxnSpPr>
          <p:nvPr/>
        </p:nvCxnSpPr>
        <p:spPr>
          <a:xfrm>
            <a:off x="6473580" y="1179142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DC9ABD0A-8C17-B94D-A3A8-C1A0FC5FA95A}"/>
              </a:ext>
            </a:extLst>
          </p:cNvPr>
          <p:cNvCxnSpPr>
            <a:cxnSpLocks/>
          </p:cNvCxnSpPr>
          <p:nvPr/>
        </p:nvCxnSpPr>
        <p:spPr>
          <a:xfrm>
            <a:off x="7522915" y="1153217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4AE5154D-8589-134C-9585-E38585188821}"/>
              </a:ext>
            </a:extLst>
          </p:cNvPr>
          <p:cNvSpPr txBox="1"/>
          <p:nvPr/>
        </p:nvSpPr>
        <p:spPr>
          <a:xfrm>
            <a:off x="5510075" y="1148029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0 min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0DC14FA-5251-6E41-90A4-35C6A953FEE7}"/>
              </a:ext>
            </a:extLst>
          </p:cNvPr>
          <p:cNvSpPr txBox="1"/>
          <p:nvPr/>
        </p:nvSpPr>
        <p:spPr>
          <a:xfrm>
            <a:off x="6545238" y="1161443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5 min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7618933-C90E-E54D-8F81-C272538A86F3}"/>
              </a:ext>
            </a:extLst>
          </p:cNvPr>
          <p:cNvSpPr txBox="1"/>
          <p:nvPr/>
        </p:nvSpPr>
        <p:spPr>
          <a:xfrm>
            <a:off x="7586692" y="1172736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0 min</a:t>
            </a: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1CE3BB52-3627-0E44-AE04-A9864AACB996}"/>
              </a:ext>
            </a:extLst>
          </p:cNvPr>
          <p:cNvSpPr/>
          <p:nvPr/>
        </p:nvSpPr>
        <p:spPr>
          <a:xfrm>
            <a:off x="3336940" y="3689370"/>
            <a:ext cx="796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</a:t>
            </a:r>
            <a:r>
              <a:rPr lang="en-US" dirty="0">
                <a:solidFill>
                  <a:prstClr val="black"/>
                </a:solidFill>
                <a:cs typeface="Arial" panose="020B0604020202020204" pitchFamily="34" charset="0"/>
              </a:rPr>
              <a:t>FLAG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EFB319C-01FB-CF45-B370-A688D5811BFC}"/>
              </a:ext>
            </a:extLst>
          </p:cNvPr>
          <p:cNvSpPr txBox="1"/>
          <p:nvPr/>
        </p:nvSpPr>
        <p:spPr>
          <a:xfrm>
            <a:off x="8919885" y="4400089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2D0DA33-455E-C74C-A4FE-3F9B5D705F35}"/>
              </a:ext>
            </a:extLst>
          </p:cNvPr>
          <p:cNvCxnSpPr>
            <a:cxnSpLocks/>
          </p:cNvCxnSpPr>
          <p:nvPr/>
        </p:nvCxnSpPr>
        <p:spPr>
          <a:xfrm flipH="1">
            <a:off x="8687413" y="4595518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3C37B689-6B36-1740-81D0-715391613210}"/>
              </a:ext>
            </a:extLst>
          </p:cNvPr>
          <p:cNvCxnSpPr>
            <a:cxnSpLocks/>
          </p:cNvCxnSpPr>
          <p:nvPr/>
        </p:nvCxnSpPr>
        <p:spPr>
          <a:xfrm flipH="1">
            <a:off x="8694207" y="5296318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DB45A5D7-91CB-204C-A340-B265AAA3482A}"/>
              </a:ext>
            </a:extLst>
          </p:cNvPr>
          <p:cNvSpPr/>
          <p:nvPr/>
        </p:nvSpPr>
        <p:spPr>
          <a:xfrm>
            <a:off x="8919885" y="3743257"/>
            <a:ext cx="23628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ytTM-SpoIVFB dimer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C112A1D-8ADD-B74C-9F34-D182455DA6B6}"/>
              </a:ext>
            </a:extLst>
          </p:cNvPr>
          <p:cNvCxnSpPr>
            <a:cxnSpLocks/>
          </p:cNvCxnSpPr>
          <p:nvPr/>
        </p:nvCxnSpPr>
        <p:spPr>
          <a:xfrm flipH="1">
            <a:off x="8699707" y="3929325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ECB1A0D-6AAD-FD49-AEFF-54C7A587AF7B}"/>
              </a:ext>
            </a:extLst>
          </p:cNvPr>
          <p:cNvSpPr txBox="1"/>
          <p:nvPr/>
        </p:nvSpPr>
        <p:spPr>
          <a:xfrm>
            <a:off x="8919885" y="5090449"/>
            <a:ext cx="2362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tTM-SpoIVFB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DACC3933-0A3A-D04F-84BC-92D7B856312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82830" y="2134652"/>
            <a:ext cx="4381500" cy="386080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2642970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F8BD83-931F-E144-B9DE-7C674F6B90B1}"/>
              </a:ext>
            </a:extLst>
          </p:cNvPr>
          <p:cNvSpPr txBox="1"/>
          <p:nvPr/>
        </p:nvSpPr>
        <p:spPr>
          <a:xfrm>
            <a:off x="632494" y="1172736"/>
            <a:ext cx="7360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Set1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25C9830D-339D-2140-B7CD-A7DA8B9FFF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9294524"/>
              </p:ext>
            </p:extLst>
          </p:nvPr>
        </p:nvGraphicFramePr>
        <p:xfrm>
          <a:off x="3738895" y="1425979"/>
          <a:ext cx="6682746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55185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381287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332422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501173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303441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333955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559280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363072">
                  <a:extLst>
                    <a:ext uri="{9D8B030D-6E8A-4147-A177-3AD203B41FA5}">
                      <a16:colId xmlns:a16="http://schemas.microsoft.com/office/drawing/2014/main" val="148875133"/>
                    </a:ext>
                  </a:extLst>
                </a:gridCol>
                <a:gridCol w="326003">
                  <a:extLst>
                    <a:ext uri="{9D8B030D-6E8A-4147-A177-3AD203B41FA5}">
                      <a16:colId xmlns:a16="http://schemas.microsoft.com/office/drawing/2014/main" val="1233904705"/>
                    </a:ext>
                  </a:extLst>
                </a:gridCol>
                <a:gridCol w="445273">
                  <a:extLst>
                    <a:ext uri="{9D8B030D-6E8A-4147-A177-3AD203B41FA5}">
                      <a16:colId xmlns:a16="http://schemas.microsoft.com/office/drawing/2014/main" val="3656884100"/>
                    </a:ext>
                  </a:extLst>
                </a:gridCol>
                <a:gridCol w="349857">
                  <a:extLst>
                    <a:ext uri="{9D8B030D-6E8A-4147-A177-3AD203B41FA5}">
                      <a16:colId xmlns:a16="http://schemas.microsoft.com/office/drawing/2014/main" val="2509758925"/>
                    </a:ext>
                  </a:extLst>
                </a:gridCol>
                <a:gridCol w="373712">
                  <a:extLst>
                    <a:ext uri="{9D8B030D-6E8A-4147-A177-3AD203B41FA5}">
                      <a16:colId xmlns:a16="http://schemas.microsoft.com/office/drawing/2014/main" val="1113358615"/>
                    </a:ext>
                  </a:extLst>
                </a:gridCol>
                <a:gridCol w="357193">
                  <a:extLst>
                    <a:ext uri="{9D8B030D-6E8A-4147-A177-3AD203B41FA5}">
                      <a16:colId xmlns:a16="http://schemas.microsoft.com/office/drawing/2014/main" val="2422224856"/>
                    </a:ext>
                  </a:extLst>
                </a:gridCol>
                <a:gridCol w="290945">
                  <a:extLst>
                    <a:ext uri="{9D8B030D-6E8A-4147-A177-3AD203B41FA5}">
                      <a16:colId xmlns:a16="http://schemas.microsoft.com/office/drawing/2014/main" val="1253338770"/>
                    </a:ext>
                  </a:extLst>
                </a:gridCol>
                <a:gridCol w="346364">
                  <a:extLst>
                    <a:ext uri="{9D8B030D-6E8A-4147-A177-3AD203B41FA5}">
                      <a16:colId xmlns:a16="http://schemas.microsoft.com/office/drawing/2014/main" val="2419459170"/>
                    </a:ext>
                  </a:extLst>
                </a:gridCol>
                <a:gridCol w="863584">
                  <a:extLst>
                    <a:ext uri="{9D8B030D-6E8A-4147-A177-3AD203B41FA5}">
                      <a16:colId xmlns:a16="http://schemas.microsoft.com/office/drawing/2014/main" val="405931063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800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r>
                        <a:rPr lang="en-US" sz="1800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83DE2251-F7E1-3E42-B923-8EB624AE6126}"/>
              </a:ext>
            </a:extLst>
          </p:cNvPr>
          <p:cNvSpPr/>
          <p:nvPr/>
        </p:nvSpPr>
        <p:spPr>
          <a:xfrm>
            <a:off x="5539999" y="485303"/>
            <a:ext cx="22436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/>
              <a:t>No Inhibitory Proteins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0B1C1C5-BFF8-FF4D-8A0E-24B06406C54B}"/>
              </a:ext>
            </a:extLst>
          </p:cNvPr>
          <p:cNvCxnSpPr>
            <a:cxnSpLocks/>
          </p:cNvCxnSpPr>
          <p:nvPr/>
        </p:nvCxnSpPr>
        <p:spPr>
          <a:xfrm>
            <a:off x="4212928" y="883815"/>
            <a:ext cx="474655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8C9592F-49D7-0844-99C2-8DB7C7D943FF}"/>
              </a:ext>
            </a:extLst>
          </p:cNvPr>
          <p:cNvSpPr txBox="1"/>
          <p:nvPr/>
        </p:nvSpPr>
        <p:spPr>
          <a:xfrm>
            <a:off x="5248722" y="829418"/>
            <a:ext cx="29600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ngle-</a:t>
            </a:r>
            <a:r>
              <a:rPr lang="en-US" dirty="0" err="1"/>
              <a:t>Cys</a:t>
            </a:r>
            <a:r>
              <a:rPr lang="en-US" dirty="0"/>
              <a:t> 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 L41C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737BF3F-6EE7-7A48-85B4-D3C35E84D4BD}"/>
              </a:ext>
            </a:extLst>
          </p:cNvPr>
          <p:cNvCxnSpPr>
            <a:cxnSpLocks/>
          </p:cNvCxnSpPr>
          <p:nvPr/>
        </p:nvCxnSpPr>
        <p:spPr>
          <a:xfrm>
            <a:off x="4187369" y="1153963"/>
            <a:ext cx="477211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DADAD4B-A451-BF44-9398-55F086826971}"/>
              </a:ext>
            </a:extLst>
          </p:cNvPr>
          <p:cNvSpPr txBox="1"/>
          <p:nvPr/>
        </p:nvSpPr>
        <p:spPr>
          <a:xfrm>
            <a:off x="4417843" y="1148029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5 min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FE3AA2A-12E4-264D-A90B-64D156CF03CF}"/>
              </a:ext>
            </a:extLst>
          </p:cNvPr>
          <p:cNvCxnSpPr>
            <a:cxnSpLocks/>
          </p:cNvCxnSpPr>
          <p:nvPr/>
        </p:nvCxnSpPr>
        <p:spPr>
          <a:xfrm>
            <a:off x="5362670" y="1160379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A92A573A-4C4F-D440-AC61-E15E2828EC10}"/>
              </a:ext>
            </a:extLst>
          </p:cNvPr>
          <p:cNvCxnSpPr>
            <a:cxnSpLocks/>
          </p:cNvCxnSpPr>
          <p:nvPr/>
        </p:nvCxnSpPr>
        <p:spPr>
          <a:xfrm>
            <a:off x="6545772" y="1179142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DC9ABD0A-8C17-B94D-A3A8-C1A0FC5FA95A}"/>
              </a:ext>
            </a:extLst>
          </p:cNvPr>
          <p:cNvCxnSpPr>
            <a:cxnSpLocks/>
          </p:cNvCxnSpPr>
          <p:nvPr/>
        </p:nvCxnSpPr>
        <p:spPr>
          <a:xfrm>
            <a:off x="7755180" y="1153217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4AE5154D-8589-134C-9585-E38585188821}"/>
              </a:ext>
            </a:extLst>
          </p:cNvPr>
          <p:cNvSpPr txBox="1"/>
          <p:nvPr/>
        </p:nvSpPr>
        <p:spPr>
          <a:xfrm>
            <a:off x="5557781" y="1148029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0 min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0DC14FA-5251-6E41-90A4-35C6A953FEE7}"/>
              </a:ext>
            </a:extLst>
          </p:cNvPr>
          <p:cNvSpPr txBox="1"/>
          <p:nvPr/>
        </p:nvSpPr>
        <p:spPr>
          <a:xfrm>
            <a:off x="6807628" y="1161443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5 min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7618933-C90E-E54D-8F81-C272538A86F3}"/>
              </a:ext>
            </a:extLst>
          </p:cNvPr>
          <p:cNvSpPr txBox="1"/>
          <p:nvPr/>
        </p:nvSpPr>
        <p:spPr>
          <a:xfrm>
            <a:off x="7928594" y="1172736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0 min</a:t>
            </a: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1CE3BB52-3627-0E44-AE04-A9864AACB996}"/>
              </a:ext>
            </a:extLst>
          </p:cNvPr>
          <p:cNvSpPr/>
          <p:nvPr/>
        </p:nvSpPr>
        <p:spPr>
          <a:xfrm>
            <a:off x="3336940" y="3689370"/>
            <a:ext cx="796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</a:t>
            </a:r>
            <a:r>
              <a:rPr lang="en-US" dirty="0">
                <a:solidFill>
                  <a:prstClr val="black"/>
                </a:solidFill>
                <a:cs typeface="Arial" panose="020B0604020202020204" pitchFamily="34" charset="0"/>
              </a:rPr>
              <a:t>FLAG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EFB319C-01FB-CF45-B370-A688D5811BFC}"/>
              </a:ext>
            </a:extLst>
          </p:cNvPr>
          <p:cNvSpPr txBox="1"/>
          <p:nvPr/>
        </p:nvSpPr>
        <p:spPr>
          <a:xfrm>
            <a:off x="9222488" y="4312625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2D0DA33-455E-C74C-A4FE-3F9B5D705F35}"/>
              </a:ext>
            </a:extLst>
          </p:cNvPr>
          <p:cNvCxnSpPr>
            <a:cxnSpLocks/>
          </p:cNvCxnSpPr>
          <p:nvPr/>
        </p:nvCxnSpPr>
        <p:spPr>
          <a:xfrm flipH="1">
            <a:off x="8990016" y="4508054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3C37B689-6B36-1740-81D0-715391613210}"/>
              </a:ext>
            </a:extLst>
          </p:cNvPr>
          <p:cNvCxnSpPr>
            <a:cxnSpLocks/>
          </p:cNvCxnSpPr>
          <p:nvPr/>
        </p:nvCxnSpPr>
        <p:spPr>
          <a:xfrm flipH="1">
            <a:off x="8996810" y="5208854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DB45A5D7-91CB-204C-A340-B265AAA3482A}"/>
              </a:ext>
            </a:extLst>
          </p:cNvPr>
          <p:cNvSpPr/>
          <p:nvPr/>
        </p:nvSpPr>
        <p:spPr>
          <a:xfrm>
            <a:off x="9222488" y="3695548"/>
            <a:ext cx="23628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ytTM-SpoIVFB dimer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C112A1D-8ADD-B74C-9F34-D182455DA6B6}"/>
              </a:ext>
            </a:extLst>
          </p:cNvPr>
          <p:cNvCxnSpPr>
            <a:cxnSpLocks/>
          </p:cNvCxnSpPr>
          <p:nvPr/>
        </p:nvCxnSpPr>
        <p:spPr>
          <a:xfrm flipH="1">
            <a:off x="9002310" y="3881616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ECB1A0D-6AAD-FD49-AEFF-54C7A587AF7B}"/>
              </a:ext>
            </a:extLst>
          </p:cNvPr>
          <p:cNvSpPr txBox="1"/>
          <p:nvPr/>
        </p:nvSpPr>
        <p:spPr>
          <a:xfrm>
            <a:off x="9222488" y="5018888"/>
            <a:ext cx="2362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tTM-SpoIVFB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B3DF97A8-60BB-5946-8FF6-B64F6DD364A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6730" b="2730"/>
          <a:stretch/>
        </p:blipFill>
        <p:spPr>
          <a:xfrm>
            <a:off x="4210414" y="2134652"/>
            <a:ext cx="1130300" cy="371401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1C3A80B8-F864-4A4C-8575-A177D5AEC51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7598" b="1863"/>
          <a:stretch/>
        </p:blipFill>
        <p:spPr>
          <a:xfrm>
            <a:off x="5404929" y="2134652"/>
            <a:ext cx="1117600" cy="371401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4F5E592F-7703-9543-8688-7E0D9A4618EC}"/>
              </a:ext>
            </a:extLst>
          </p:cNvPr>
          <p:cNvSpPr txBox="1"/>
          <p:nvPr/>
        </p:nvSpPr>
        <p:spPr>
          <a:xfrm>
            <a:off x="6789411" y="598275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20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8CC2547-E49E-4148-875D-BB859C397DDA}"/>
              </a:ext>
            </a:extLst>
          </p:cNvPr>
          <p:cNvSpPr txBox="1"/>
          <p:nvPr/>
        </p:nvSpPr>
        <p:spPr>
          <a:xfrm>
            <a:off x="5517216" y="5982752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lasmid#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FD1AF9CC-D8C3-9F4B-8765-847289633B9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3461" b="2807"/>
          <a:stretch/>
        </p:blipFill>
        <p:spPr>
          <a:xfrm>
            <a:off x="6582767" y="2134652"/>
            <a:ext cx="1155700" cy="371401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574E1D2-9DBD-B849-B673-1E5219BF4B2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3027" b="3422"/>
          <a:stretch/>
        </p:blipFill>
        <p:spPr>
          <a:xfrm>
            <a:off x="7816479" y="2141814"/>
            <a:ext cx="1143000" cy="3706851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40426623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F8BD83-931F-E144-B9DE-7C674F6B90B1}"/>
              </a:ext>
            </a:extLst>
          </p:cNvPr>
          <p:cNvSpPr txBox="1"/>
          <p:nvPr/>
        </p:nvSpPr>
        <p:spPr>
          <a:xfrm>
            <a:off x="632494" y="1172736"/>
            <a:ext cx="7360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Set2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25C9830D-339D-2140-B7CD-A7DA8B9FFF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0708951"/>
              </p:ext>
            </p:extLst>
          </p:nvPr>
        </p:nvGraphicFramePr>
        <p:xfrm>
          <a:off x="3675286" y="1425979"/>
          <a:ext cx="6682746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32695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384463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332509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420400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378436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368208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450032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339216">
                  <a:extLst>
                    <a:ext uri="{9D8B030D-6E8A-4147-A177-3AD203B41FA5}">
                      <a16:colId xmlns:a16="http://schemas.microsoft.com/office/drawing/2014/main" val="148875133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1233904705"/>
                    </a:ext>
                  </a:extLst>
                </a:gridCol>
                <a:gridCol w="431539">
                  <a:extLst>
                    <a:ext uri="{9D8B030D-6E8A-4147-A177-3AD203B41FA5}">
                      <a16:colId xmlns:a16="http://schemas.microsoft.com/office/drawing/2014/main" val="3656884100"/>
                    </a:ext>
                  </a:extLst>
                </a:gridCol>
                <a:gridCol w="323835">
                  <a:extLst>
                    <a:ext uri="{9D8B030D-6E8A-4147-A177-3AD203B41FA5}">
                      <a16:colId xmlns:a16="http://schemas.microsoft.com/office/drawing/2014/main" val="2509758925"/>
                    </a:ext>
                  </a:extLst>
                </a:gridCol>
                <a:gridCol w="357809">
                  <a:extLst>
                    <a:ext uri="{9D8B030D-6E8A-4147-A177-3AD203B41FA5}">
                      <a16:colId xmlns:a16="http://schemas.microsoft.com/office/drawing/2014/main" val="1113358615"/>
                    </a:ext>
                  </a:extLst>
                </a:gridCol>
                <a:gridCol w="396951">
                  <a:extLst>
                    <a:ext uri="{9D8B030D-6E8A-4147-A177-3AD203B41FA5}">
                      <a16:colId xmlns:a16="http://schemas.microsoft.com/office/drawing/2014/main" val="2422224856"/>
                    </a:ext>
                  </a:extLst>
                </a:gridCol>
                <a:gridCol w="290945">
                  <a:extLst>
                    <a:ext uri="{9D8B030D-6E8A-4147-A177-3AD203B41FA5}">
                      <a16:colId xmlns:a16="http://schemas.microsoft.com/office/drawing/2014/main" val="1253338770"/>
                    </a:ext>
                  </a:extLst>
                </a:gridCol>
                <a:gridCol w="346364">
                  <a:extLst>
                    <a:ext uri="{9D8B030D-6E8A-4147-A177-3AD203B41FA5}">
                      <a16:colId xmlns:a16="http://schemas.microsoft.com/office/drawing/2014/main" val="2419459170"/>
                    </a:ext>
                  </a:extLst>
                </a:gridCol>
                <a:gridCol w="863584">
                  <a:extLst>
                    <a:ext uri="{9D8B030D-6E8A-4147-A177-3AD203B41FA5}">
                      <a16:colId xmlns:a16="http://schemas.microsoft.com/office/drawing/2014/main" val="405931063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800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r>
                        <a:rPr lang="en-US" sz="1800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83DE2251-F7E1-3E42-B923-8EB624AE6126}"/>
              </a:ext>
            </a:extLst>
          </p:cNvPr>
          <p:cNvSpPr/>
          <p:nvPr/>
        </p:nvSpPr>
        <p:spPr>
          <a:xfrm>
            <a:off x="5539999" y="485303"/>
            <a:ext cx="22436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/>
              <a:t>No Inhibitory Proteins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0B1C1C5-BFF8-FF4D-8A0E-24B06406C54B}"/>
              </a:ext>
            </a:extLst>
          </p:cNvPr>
          <p:cNvCxnSpPr>
            <a:cxnSpLocks/>
          </p:cNvCxnSpPr>
          <p:nvPr/>
        </p:nvCxnSpPr>
        <p:spPr>
          <a:xfrm>
            <a:off x="4212928" y="883815"/>
            <a:ext cx="474655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8C9592F-49D7-0844-99C2-8DB7C7D943FF}"/>
              </a:ext>
            </a:extLst>
          </p:cNvPr>
          <p:cNvSpPr txBox="1"/>
          <p:nvPr/>
        </p:nvSpPr>
        <p:spPr>
          <a:xfrm>
            <a:off x="5248722" y="829418"/>
            <a:ext cx="29600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ngle-</a:t>
            </a:r>
            <a:r>
              <a:rPr lang="en-US" dirty="0" err="1"/>
              <a:t>Cys</a:t>
            </a:r>
            <a:r>
              <a:rPr lang="en-US" dirty="0"/>
              <a:t> 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 L41C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737BF3F-6EE7-7A48-85B4-D3C35E84D4BD}"/>
              </a:ext>
            </a:extLst>
          </p:cNvPr>
          <p:cNvCxnSpPr>
            <a:cxnSpLocks/>
          </p:cNvCxnSpPr>
          <p:nvPr/>
        </p:nvCxnSpPr>
        <p:spPr>
          <a:xfrm>
            <a:off x="4187369" y="1153963"/>
            <a:ext cx="477211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DADAD4B-A451-BF44-9398-55F086826971}"/>
              </a:ext>
            </a:extLst>
          </p:cNvPr>
          <p:cNvSpPr txBox="1"/>
          <p:nvPr/>
        </p:nvSpPr>
        <p:spPr>
          <a:xfrm>
            <a:off x="4449648" y="1148029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5 min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FE3AA2A-12E4-264D-A90B-64D156CF03CF}"/>
              </a:ext>
            </a:extLst>
          </p:cNvPr>
          <p:cNvCxnSpPr>
            <a:cxnSpLocks/>
          </p:cNvCxnSpPr>
          <p:nvPr/>
        </p:nvCxnSpPr>
        <p:spPr>
          <a:xfrm>
            <a:off x="5383452" y="1160379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A92A573A-4C4F-D440-AC61-E15E2828EC10}"/>
              </a:ext>
            </a:extLst>
          </p:cNvPr>
          <p:cNvCxnSpPr>
            <a:cxnSpLocks/>
          </p:cNvCxnSpPr>
          <p:nvPr/>
        </p:nvCxnSpPr>
        <p:spPr>
          <a:xfrm>
            <a:off x="6556163" y="1179142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DC9ABD0A-8C17-B94D-A3A8-C1A0FC5FA95A}"/>
              </a:ext>
            </a:extLst>
          </p:cNvPr>
          <p:cNvCxnSpPr>
            <a:cxnSpLocks/>
          </p:cNvCxnSpPr>
          <p:nvPr/>
        </p:nvCxnSpPr>
        <p:spPr>
          <a:xfrm>
            <a:off x="7692834" y="1153217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4AE5154D-8589-134C-9585-E38585188821}"/>
              </a:ext>
            </a:extLst>
          </p:cNvPr>
          <p:cNvSpPr txBox="1"/>
          <p:nvPr/>
        </p:nvSpPr>
        <p:spPr>
          <a:xfrm>
            <a:off x="5557781" y="1148029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0 min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0DC14FA-5251-6E41-90A4-35C6A953FEE7}"/>
              </a:ext>
            </a:extLst>
          </p:cNvPr>
          <p:cNvSpPr txBox="1"/>
          <p:nvPr/>
        </p:nvSpPr>
        <p:spPr>
          <a:xfrm>
            <a:off x="6728115" y="1161443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5 min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7618933-C90E-E54D-8F81-C272538A86F3}"/>
              </a:ext>
            </a:extLst>
          </p:cNvPr>
          <p:cNvSpPr txBox="1"/>
          <p:nvPr/>
        </p:nvSpPr>
        <p:spPr>
          <a:xfrm>
            <a:off x="7904742" y="1172736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0 min</a:t>
            </a: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1CE3BB52-3627-0E44-AE04-A9864AACB996}"/>
              </a:ext>
            </a:extLst>
          </p:cNvPr>
          <p:cNvSpPr/>
          <p:nvPr/>
        </p:nvSpPr>
        <p:spPr>
          <a:xfrm>
            <a:off x="3336940" y="3689370"/>
            <a:ext cx="796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</a:t>
            </a:r>
            <a:r>
              <a:rPr lang="en-US" dirty="0">
                <a:solidFill>
                  <a:prstClr val="black"/>
                </a:solidFill>
                <a:cs typeface="Arial" panose="020B0604020202020204" pitchFamily="34" charset="0"/>
              </a:rPr>
              <a:t>FLAG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EFB319C-01FB-CF45-B370-A688D5811BFC}"/>
              </a:ext>
            </a:extLst>
          </p:cNvPr>
          <p:cNvSpPr txBox="1"/>
          <p:nvPr/>
        </p:nvSpPr>
        <p:spPr>
          <a:xfrm>
            <a:off x="9113698" y="4363402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2D0DA33-455E-C74C-A4FE-3F9B5D705F35}"/>
              </a:ext>
            </a:extLst>
          </p:cNvPr>
          <p:cNvCxnSpPr>
            <a:cxnSpLocks/>
          </p:cNvCxnSpPr>
          <p:nvPr/>
        </p:nvCxnSpPr>
        <p:spPr>
          <a:xfrm flipH="1">
            <a:off x="8881226" y="4558831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3C37B689-6B36-1740-81D0-715391613210}"/>
              </a:ext>
            </a:extLst>
          </p:cNvPr>
          <p:cNvCxnSpPr>
            <a:cxnSpLocks/>
          </p:cNvCxnSpPr>
          <p:nvPr/>
        </p:nvCxnSpPr>
        <p:spPr>
          <a:xfrm flipH="1">
            <a:off x="8888020" y="5259631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DB45A5D7-91CB-204C-A340-B265AAA3482A}"/>
              </a:ext>
            </a:extLst>
          </p:cNvPr>
          <p:cNvSpPr/>
          <p:nvPr/>
        </p:nvSpPr>
        <p:spPr>
          <a:xfrm>
            <a:off x="9113698" y="3744432"/>
            <a:ext cx="23628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ytTM-SpoIVFB dimer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C112A1D-8ADD-B74C-9F34-D182455DA6B6}"/>
              </a:ext>
            </a:extLst>
          </p:cNvPr>
          <p:cNvCxnSpPr>
            <a:cxnSpLocks/>
          </p:cNvCxnSpPr>
          <p:nvPr/>
        </p:nvCxnSpPr>
        <p:spPr>
          <a:xfrm flipH="1">
            <a:off x="8893520" y="3930500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ECB1A0D-6AAD-FD49-AEFF-54C7A587AF7B}"/>
              </a:ext>
            </a:extLst>
          </p:cNvPr>
          <p:cNvSpPr txBox="1"/>
          <p:nvPr/>
        </p:nvSpPr>
        <p:spPr>
          <a:xfrm>
            <a:off x="9113698" y="5059063"/>
            <a:ext cx="2362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tTM-SpoIVFB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F5E592F-7703-9543-8688-7E0D9A4618EC}"/>
              </a:ext>
            </a:extLst>
          </p:cNvPr>
          <p:cNvSpPr txBox="1"/>
          <p:nvPr/>
        </p:nvSpPr>
        <p:spPr>
          <a:xfrm>
            <a:off x="6789411" y="598275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20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8CC2547-E49E-4148-875D-BB859C397DDA}"/>
              </a:ext>
            </a:extLst>
          </p:cNvPr>
          <p:cNvSpPr txBox="1"/>
          <p:nvPr/>
        </p:nvSpPr>
        <p:spPr>
          <a:xfrm>
            <a:off x="5517216" y="5982752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lasmid#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9091CCC-4A27-C54D-99A3-553424A9161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3728" b="3728"/>
          <a:stretch/>
        </p:blipFill>
        <p:spPr>
          <a:xfrm>
            <a:off x="4274575" y="2134652"/>
            <a:ext cx="1066800" cy="371401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0650DF01-C7BA-0348-9945-945717A7F27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2901" b="4554"/>
          <a:stretch/>
        </p:blipFill>
        <p:spPr>
          <a:xfrm>
            <a:off x="5433519" y="2134652"/>
            <a:ext cx="1092200" cy="371401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052C0015-70EF-0E4F-BB68-86340F698EA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1165" b="3450"/>
          <a:stretch/>
        </p:blipFill>
        <p:spPr>
          <a:xfrm>
            <a:off x="6603372" y="2141814"/>
            <a:ext cx="1054100" cy="370685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079B2942-F53D-CD4F-8F06-4F8B682E10B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1355" b="3077"/>
          <a:stretch/>
        </p:blipFill>
        <p:spPr>
          <a:xfrm>
            <a:off x="7728874" y="2134652"/>
            <a:ext cx="1117600" cy="3714014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08330065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F8BD83-931F-E144-B9DE-7C674F6B90B1}"/>
              </a:ext>
            </a:extLst>
          </p:cNvPr>
          <p:cNvSpPr txBox="1"/>
          <p:nvPr/>
        </p:nvSpPr>
        <p:spPr>
          <a:xfrm>
            <a:off x="632494" y="1172736"/>
            <a:ext cx="7360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Set1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25C9830D-339D-2140-B7CD-A7DA8B9FFF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20787547"/>
              </p:ext>
            </p:extLst>
          </p:nvPr>
        </p:nvGraphicFramePr>
        <p:xfrm>
          <a:off x="3778650" y="1425979"/>
          <a:ext cx="6682746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55185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293824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318052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508884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357808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318053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540688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333955">
                  <a:extLst>
                    <a:ext uri="{9D8B030D-6E8A-4147-A177-3AD203B41FA5}">
                      <a16:colId xmlns:a16="http://schemas.microsoft.com/office/drawing/2014/main" val="148875133"/>
                    </a:ext>
                  </a:extLst>
                </a:gridCol>
                <a:gridCol w="357809">
                  <a:extLst>
                    <a:ext uri="{9D8B030D-6E8A-4147-A177-3AD203B41FA5}">
                      <a16:colId xmlns:a16="http://schemas.microsoft.com/office/drawing/2014/main" val="1233904705"/>
                    </a:ext>
                  </a:extLst>
                </a:gridCol>
                <a:gridCol w="477078">
                  <a:extLst>
                    <a:ext uri="{9D8B030D-6E8A-4147-A177-3AD203B41FA5}">
                      <a16:colId xmlns:a16="http://schemas.microsoft.com/office/drawing/2014/main" val="3656884100"/>
                    </a:ext>
                  </a:extLst>
                </a:gridCol>
                <a:gridCol w="326004">
                  <a:extLst>
                    <a:ext uri="{9D8B030D-6E8A-4147-A177-3AD203B41FA5}">
                      <a16:colId xmlns:a16="http://schemas.microsoft.com/office/drawing/2014/main" val="2509758925"/>
                    </a:ext>
                  </a:extLst>
                </a:gridCol>
                <a:gridCol w="341906">
                  <a:extLst>
                    <a:ext uri="{9D8B030D-6E8A-4147-A177-3AD203B41FA5}">
                      <a16:colId xmlns:a16="http://schemas.microsoft.com/office/drawing/2014/main" val="1113358615"/>
                    </a:ext>
                  </a:extLst>
                </a:gridCol>
                <a:gridCol w="452607">
                  <a:extLst>
                    <a:ext uri="{9D8B030D-6E8A-4147-A177-3AD203B41FA5}">
                      <a16:colId xmlns:a16="http://schemas.microsoft.com/office/drawing/2014/main" val="2422224856"/>
                    </a:ext>
                  </a:extLst>
                </a:gridCol>
                <a:gridCol w="290945">
                  <a:extLst>
                    <a:ext uri="{9D8B030D-6E8A-4147-A177-3AD203B41FA5}">
                      <a16:colId xmlns:a16="http://schemas.microsoft.com/office/drawing/2014/main" val="1253338770"/>
                    </a:ext>
                  </a:extLst>
                </a:gridCol>
                <a:gridCol w="346364">
                  <a:extLst>
                    <a:ext uri="{9D8B030D-6E8A-4147-A177-3AD203B41FA5}">
                      <a16:colId xmlns:a16="http://schemas.microsoft.com/office/drawing/2014/main" val="2419459170"/>
                    </a:ext>
                  </a:extLst>
                </a:gridCol>
                <a:gridCol w="863584">
                  <a:extLst>
                    <a:ext uri="{9D8B030D-6E8A-4147-A177-3AD203B41FA5}">
                      <a16:colId xmlns:a16="http://schemas.microsoft.com/office/drawing/2014/main" val="405931063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800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r>
                        <a:rPr lang="en-US" sz="1800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83DE2251-F7E1-3E42-B923-8EB624AE6126}"/>
              </a:ext>
            </a:extLst>
          </p:cNvPr>
          <p:cNvSpPr/>
          <p:nvPr/>
        </p:nvSpPr>
        <p:spPr>
          <a:xfrm>
            <a:off x="5449042" y="485303"/>
            <a:ext cx="24255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/>
              <a:t>MBP</a:t>
            </a:r>
            <a:r>
              <a:rPr lang="el-GR" dirty="0"/>
              <a:t>Δ</a:t>
            </a:r>
            <a:r>
              <a:rPr lang="en-US" dirty="0"/>
              <a:t>27BofA + SpoIVFA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0B1C1C5-BFF8-FF4D-8A0E-24B06406C54B}"/>
              </a:ext>
            </a:extLst>
          </p:cNvPr>
          <p:cNvCxnSpPr>
            <a:cxnSpLocks/>
          </p:cNvCxnSpPr>
          <p:nvPr/>
        </p:nvCxnSpPr>
        <p:spPr>
          <a:xfrm>
            <a:off x="4212928" y="883815"/>
            <a:ext cx="474655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8C9592F-49D7-0844-99C2-8DB7C7D943FF}"/>
              </a:ext>
            </a:extLst>
          </p:cNvPr>
          <p:cNvSpPr txBox="1"/>
          <p:nvPr/>
        </p:nvSpPr>
        <p:spPr>
          <a:xfrm>
            <a:off x="5248722" y="829418"/>
            <a:ext cx="29600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ngle-</a:t>
            </a:r>
            <a:r>
              <a:rPr lang="en-US" dirty="0" err="1"/>
              <a:t>Cys</a:t>
            </a:r>
            <a:r>
              <a:rPr lang="en-US" dirty="0"/>
              <a:t> 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 L41C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737BF3F-6EE7-7A48-85B4-D3C35E84D4BD}"/>
              </a:ext>
            </a:extLst>
          </p:cNvPr>
          <p:cNvCxnSpPr>
            <a:cxnSpLocks/>
          </p:cNvCxnSpPr>
          <p:nvPr/>
        </p:nvCxnSpPr>
        <p:spPr>
          <a:xfrm>
            <a:off x="4187369" y="1153963"/>
            <a:ext cx="477211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DADAD4B-A451-BF44-9398-55F086826971}"/>
              </a:ext>
            </a:extLst>
          </p:cNvPr>
          <p:cNvSpPr txBox="1"/>
          <p:nvPr/>
        </p:nvSpPr>
        <p:spPr>
          <a:xfrm>
            <a:off x="4370135" y="1148029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5 min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FE3AA2A-12E4-264D-A90B-64D156CF03CF}"/>
              </a:ext>
            </a:extLst>
          </p:cNvPr>
          <p:cNvCxnSpPr>
            <a:cxnSpLocks/>
          </p:cNvCxnSpPr>
          <p:nvPr/>
        </p:nvCxnSpPr>
        <p:spPr>
          <a:xfrm>
            <a:off x="5362670" y="1160379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A92A573A-4C4F-D440-AC61-E15E2828EC10}"/>
              </a:ext>
            </a:extLst>
          </p:cNvPr>
          <p:cNvCxnSpPr>
            <a:cxnSpLocks/>
          </p:cNvCxnSpPr>
          <p:nvPr/>
        </p:nvCxnSpPr>
        <p:spPr>
          <a:xfrm>
            <a:off x="6545772" y="1179142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DC9ABD0A-8C17-B94D-A3A8-C1A0FC5FA95A}"/>
              </a:ext>
            </a:extLst>
          </p:cNvPr>
          <p:cNvCxnSpPr>
            <a:cxnSpLocks/>
          </p:cNvCxnSpPr>
          <p:nvPr/>
        </p:nvCxnSpPr>
        <p:spPr>
          <a:xfrm>
            <a:off x="7755180" y="1153217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4AE5154D-8589-134C-9585-E38585188821}"/>
              </a:ext>
            </a:extLst>
          </p:cNvPr>
          <p:cNvSpPr txBox="1"/>
          <p:nvPr/>
        </p:nvSpPr>
        <p:spPr>
          <a:xfrm>
            <a:off x="5557781" y="1148029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0 min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0DC14FA-5251-6E41-90A4-35C6A953FEE7}"/>
              </a:ext>
            </a:extLst>
          </p:cNvPr>
          <p:cNvSpPr txBox="1"/>
          <p:nvPr/>
        </p:nvSpPr>
        <p:spPr>
          <a:xfrm>
            <a:off x="6751967" y="1161443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5 min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7618933-C90E-E54D-8F81-C272538A86F3}"/>
              </a:ext>
            </a:extLst>
          </p:cNvPr>
          <p:cNvSpPr txBox="1"/>
          <p:nvPr/>
        </p:nvSpPr>
        <p:spPr>
          <a:xfrm>
            <a:off x="7912693" y="1172736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0 min</a:t>
            </a: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1CE3BB52-3627-0E44-AE04-A9864AACB996}"/>
              </a:ext>
            </a:extLst>
          </p:cNvPr>
          <p:cNvSpPr/>
          <p:nvPr/>
        </p:nvSpPr>
        <p:spPr>
          <a:xfrm>
            <a:off x="3336940" y="3689370"/>
            <a:ext cx="796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</a:t>
            </a:r>
            <a:r>
              <a:rPr lang="en-US" dirty="0">
                <a:solidFill>
                  <a:prstClr val="black"/>
                </a:solidFill>
                <a:cs typeface="Arial" panose="020B0604020202020204" pitchFamily="34" charset="0"/>
              </a:rPr>
              <a:t>FLAG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EFB319C-01FB-CF45-B370-A688D5811BFC}"/>
              </a:ext>
            </a:extLst>
          </p:cNvPr>
          <p:cNvSpPr txBox="1"/>
          <p:nvPr/>
        </p:nvSpPr>
        <p:spPr>
          <a:xfrm>
            <a:off x="9199201" y="4234243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2D0DA33-455E-C74C-A4FE-3F9B5D705F35}"/>
              </a:ext>
            </a:extLst>
          </p:cNvPr>
          <p:cNvCxnSpPr>
            <a:cxnSpLocks/>
          </p:cNvCxnSpPr>
          <p:nvPr/>
        </p:nvCxnSpPr>
        <p:spPr>
          <a:xfrm flipH="1">
            <a:off x="8966729" y="4429672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3C37B689-6B36-1740-81D0-715391613210}"/>
              </a:ext>
            </a:extLst>
          </p:cNvPr>
          <p:cNvCxnSpPr>
            <a:cxnSpLocks/>
          </p:cNvCxnSpPr>
          <p:nvPr/>
        </p:nvCxnSpPr>
        <p:spPr>
          <a:xfrm flipH="1">
            <a:off x="8973523" y="5154325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DB45A5D7-91CB-204C-A340-B265AAA3482A}"/>
              </a:ext>
            </a:extLst>
          </p:cNvPr>
          <p:cNvSpPr/>
          <p:nvPr/>
        </p:nvSpPr>
        <p:spPr>
          <a:xfrm>
            <a:off x="9199201" y="3640457"/>
            <a:ext cx="23628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ytTM-SpoIVFB dimer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C112A1D-8ADD-B74C-9F34-D182455DA6B6}"/>
              </a:ext>
            </a:extLst>
          </p:cNvPr>
          <p:cNvCxnSpPr>
            <a:cxnSpLocks/>
          </p:cNvCxnSpPr>
          <p:nvPr/>
        </p:nvCxnSpPr>
        <p:spPr>
          <a:xfrm flipH="1">
            <a:off x="8979023" y="3826525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ECB1A0D-6AAD-FD49-AEFF-54C7A587AF7B}"/>
              </a:ext>
            </a:extLst>
          </p:cNvPr>
          <p:cNvSpPr txBox="1"/>
          <p:nvPr/>
        </p:nvSpPr>
        <p:spPr>
          <a:xfrm>
            <a:off x="9199201" y="4972310"/>
            <a:ext cx="2362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tTM-SpoIVFB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F5E592F-7703-9543-8688-7E0D9A4618EC}"/>
              </a:ext>
            </a:extLst>
          </p:cNvPr>
          <p:cNvSpPr txBox="1"/>
          <p:nvPr/>
        </p:nvSpPr>
        <p:spPr>
          <a:xfrm>
            <a:off x="6789411" y="598275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27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8CC2547-E49E-4148-875D-BB859C397DDA}"/>
              </a:ext>
            </a:extLst>
          </p:cNvPr>
          <p:cNvSpPr txBox="1"/>
          <p:nvPr/>
        </p:nvSpPr>
        <p:spPr>
          <a:xfrm>
            <a:off x="5517216" y="5982752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lasmid#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7B0EDBF-4ABB-574D-8F42-9E67CC320EC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1204"/>
          <a:stretch/>
        </p:blipFill>
        <p:spPr>
          <a:xfrm>
            <a:off x="4265375" y="2095520"/>
            <a:ext cx="1079500" cy="369886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C8A696C1-9D5F-494D-98B0-3EB79587B70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1204"/>
          <a:stretch/>
        </p:blipFill>
        <p:spPr>
          <a:xfrm>
            <a:off x="5416451" y="2095519"/>
            <a:ext cx="1092200" cy="369886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7EFB1C0F-0355-8442-B50B-CC9AD5131BA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2137"/>
          <a:stretch/>
        </p:blipFill>
        <p:spPr>
          <a:xfrm>
            <a:off x="6578976" y="2095519"/>
            <a:ext cx="1143000" cy="370375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981927D5-0B79-A24D-8906-0C93FC34D13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2265"/>
          <a:stretch/>
        </p:blipFill>
        <p:spPr>
          <a:xfrm>
            <a:off x="7793231" y="2095518"/>
            <a:ext cx="1143000" cy="3698869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47344535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F8BD83-931F-E144-B9DE-7C674F6B90B1}"/>
              </a:ext>
            </a:extLst>
          </p:cNvPr>
          <p:cNvSpPr txBox="1"/>
          <p:nvPr/>
        </p:nvSpPr>
        <p:spPr>
          <a:xfrm>
            <a:off x="632494" y="1172736"/>
            <a:ext cx="7360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Set2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25C9830D-339D-2140-B7CD-A7DA8B9FFF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90780887"/>
              </p:ext>
            </p:extLst>
          </p:nvPr>
        </p:nvGraphicFramePr>
        <p:xfrm>
          <a:off x="3707088" y="1425979"/>
          <a:ext cx="6682746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55185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373337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340372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501173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378436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368208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450032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339219">
                  <a:extLst>
                    <a:ext uri="{9D8B030D-6E8A-4147-A177-3AD203B41FA5}">
                      <a16:colId xmlns:a16="http://schemas.microsoft.com/office/drawing/2014/main" val="148875133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1233904705"/>
                    </a:ext>
                  </a:extLst>
                </a:gridCol>
                <a:gridCol w="485030">
                  <a:extLst>
                    <a:ext uri="{9D8B030D-6E8A-4147-A177-3AD203B41FA5}">
                      <a16:colId xmlns:a16="http://schemas.microsoft.com/office/drawing/2014/main" val="3656884100"/>
                    </a:ext>
                  </a:extLst>
                </a:gridCol>
                <a:gridCol w="326003">
                  <a:extLst>
                    <a:ext uri="{9D8B030D-6E8A-4147-A177-3AD203B41FA5}">
                      <a16:colId xmlns:a16="http://schemas.microsoft.com/office/drawing/2014/main" val="2509758925"/>
                    </a:ext>
                  </a:extLst>
                </a:gridCol>
                <a:gridCol w="310101">
                  <a:extLst>
                    <a:ext uri="{9D8B030D-6E8A-4147-A177-3AD203B41FA5}">
                      <a16:colId xmlns:a16="http://schemas.microsoft.com/office/drawing/2014/main" val="1113358615"/>
                    </a:ext>
                  </a:extLst>
                </a:gridCol>
                <a:gridCol w="388997">
                  <a:extLst>
                    <a:ext uri="{9D8B030D-6E8A-4147-A177-3AD203B41FA5}">
                      <a16:colId xmlns:a16="http://schemas.microsoft.com/office/drawing/2014/main" val="2422224856"/>
                    </a:ext>
                  </a:extLst>
                </a:gridCol>
                <a:gridCol w="290945">
                  <a:extLst>
                    <a:ext uri="{9D8B030D-6E8A-4147-A177-3AD203B41FA5}">
                      <a16:colId xmlns:a16="http://schemas.microsoft.com/office/drawing/2014/main" val="1253338770"/>
                    </a:ext>
                  </a:extLst>
                </a:gridCol>
                <a:gridCol w="346364">
                  <a:extLst>
                    <a:ext uri="{9D8B030D-6E8A-4147-A177-3AD203B41FA5}">
                      <a16:colId xmlns:a16="http://schemas.microsoft.com/office/drawing/2014/main" val="2419459170"/>
                    </a:ext>
                  </a:extLst>
                </a:gridCol>
                <a:gridCol w="863584">
                  <a:extLst>
                    <a:ext uri="{9D8B030D-6E8A-4147-A177-3AD203B41FA5}">
                      <a16:colId xmlns:a16="http://schemas.microsoft.com/office/drawing/2014/main" val="405931063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800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r>
                        <a:rPr lang="en-US" sz="1800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83DE2251-F7E1-3E42-B923-8EB624AE6126}"/>
              </a:ext>
            </a:extLst>
          </p:cNvPr>
          <p:cNvSpPr/>
          <p:nvPr/>
        </p:nvSpPr>
        <p:spPr>
          <a:xfrm>
            <a:off x="5449042" y="485303"/>
            <a:ext cx="24255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/>
              <a:t>MBP</a:t>
            </a:r>
            <a:r>
              <a:rPr lang="el-GR" dirty="0"/>
              <a:t>Δ</a:t>
            </a:r>
            <a:r>
              <a:rPr lang="en-US" dirty="0"/>
              <a:t>27BofA + SpoIVFA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0B1C1C5-BFF8-FF4D-8A0E-24B06406C54B}"/>
              </a:ext>
            </a:extLst>
          </p:cNvPr>
          <p:cNvCxnSpPr>
            <a:cxnSpLocks/>
          </p:cNvCxnSpPr>
          <p:nvPr/>
        </p:nvCxnSpPr>
        <p:spPr>
          <a:xfrm>
            <a:off x="4212928" y="883815"/>
            <a:ext cx="474655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8C9592F-49D7-0844-99C2-8DB7C7D943FF}"/>
              </a:ext>
            </a:extLst>
          </p:cNvPr>
          <p:cNvSpPr txBox="1"/>
          <p:nvPr/>
        </p:nvSpPr>
        <p:spPr>
          <a:xfrm>
            <a:off x="5248722" y="829418"/>
            <a:ext cx="29600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ngle-</a:t>
            </a:r>
            <a:r>
              <a:rPr lang="en-US" dirty="0" err="1"/>
              <a:t>Cys</a:t>
            </a:r>
            <a:r>
              <a:rPr lang="en-US" dirty="0"/>
              <a:t> 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 L41C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737BF3F-6EE7-7A48-85B4-D3C35E84D4BD}"/>
              </a:ext>
            </a:extLst>
          </p:cNvPr>
          <p:cNvCxnSpPr>
            <a:cxnSpLocks/>
          </p:cNvCxnSpPr>
          <p:nvPr/>
        </p:nvCxnSpPr>
        <p:spPr>
          <a:xfrm>
            <a:off x="4187369" y="1153963"/>
            <a:ext cx="477211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DADAD4B-A451-BF44-9398-55F086826971}"/>
              </a:ext>
            </a:extLst>
          </p:cNvPr>
          <p:cNvSpPr txBox="1"/>
          <p:nvPr/>
        </p:nvSpPr>
        <p:spPr>
          <a:xfrm>
            <a:off x="4382060" y="1148029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5 min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FE3AA2A-12E4-264D-A90B-64D156CF03CF}"/>
              </a:ext>
            </a:extLst>
          </p:cNvPr>
          <p:cNvCxnSpPr>
            <a:cxnSpLocks/>
          </p:cNvCxnSpPr>
          <p:nvPr/>
        </p:nvCxnSpPr>
        <p:spPr>
          <a:xfrm>
            <a:off x="5362670" y="1160379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A92A573A-4C4F-D440-AC61-E15E2828EC10}"/>
              </a:ext>
            </a:extLst>
          </p:cNvPr>
          <p:cNvCxnSpPr>
            <a:cxnSpLocks/>
          </p:cNvCxnSpPr>
          <p:nvPr/>
        </p:nvCxnSpPr>
        <p:spPr>
          <a:xfrm>
            <a:off x="6598024" y="1179142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DC9ABD0A-8C17-B94D-A3A8-C1A0FC5FA95A}"/>
              </a:ext>
            </a:extLst>
          </p:cNvPr>
          <p:cNvCxnSpPr>
            <a:cxnSpLocks/>
          </p:cNvCxnSpPr>
          <p:nvPr/>
        </p:nvCxnSpPr>
        <p:spPr>
          <a:xfrm>
            <a:off x="7768243" y="1153217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4AE5154D-8589-134C-9585-E38585188821}"/>
              </a:ext>
            </a:extLst>
          </p:cNvPr>
          <p:cNvSpPr txBox="1"/>
          <p:nvPr/>
        </p:nvSpPr>
        <p:spPr>
          <a:xfrm>
            <a:off x="5605488" y="1148029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0 min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0DC14FA-5251-6E41-90A4-35C6A953FEE7}"/>
              </a:ext>
            </a:extLst>
          </p:cNvPr>
          <p:cNvSpPr txBox="1"/>
          <p:nvPr/>
        </p:nvSpPr>
        <p:spPr>
          <a:xfrm>
            <a:off x="6760490" y="1161443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5 min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7618933-C90E-E54D-8F81-C272538A86F3}"/>
              </a:ext>
            </a:extLst>
          </p:cNvPr>
          <p:cNvSpPr txBox="1"/>
          <p:nvPr/>
        </p:nvSpPr>
        <p:spPr>
          <a:xfrm>
            <a:off x="7926324" y="1172736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0 min</a:t>
            </a: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1CE3BB52-3627-0E44-AE04-A9864AACB996}"/>
              </a:ext>
            </a:extLst>
          </p:cNvPr>
          <p:cNvSpPr/>
          <p:nvPr/>
        </p:nvSpPr>
        <p:spPr>
          <a:xfrm>
            <a:off x="3336940" y="3689370"/>
            <a:ext cx="796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</a:t>
            </a:r>
            <a:r>
              <a:rPr lang="en-US" dirty="0">
                <a:solidFill>
                  <a:prstClr val="black"/>
                </a:solidFill>
                <a:cs typeface="Arial" panose="020B0604020202020204" pitchFamily="34" charset="0"/>
              </a:rPr>
              <a:t>FLAG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EFB319C-01FB-CF45-B370-A688D5811BFC}"/>
              </a:ext>
            </a:extLst>
          </p:cNvPr>
          <p:cNvSpPr txBox="1"/>
          <p:nvPr/>
        </p:nvSpPr>
        <p:spPr>
          <a:xfrm>
            <a:off x="9159445" y="4289904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2D0DA33-455E-C74C-A4FE-3F9B5D705F35}"/>
              </a:ext>
            </a:extLst>
          </p:cNvPr>
          <p:cNvCxnSpPr>
            <a:cxnSpLocks/>
          </p:cNvCxnSpPr>
          <p:nvPr/>
        </p:nvCxnSpPr>
        <p:spPr>
          <a:xfrm flipH="1">
            <a:off x="8926973" y="4485333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3C37B689-6B36-1740-81D0-715391613210}"/>
              </a:ext>
            </a:extLst>
          </p:cNvPr>
          <p:cNvCxnSpPr>
            <a:cxnSpLocks/>
          </p:cNvCxnSpPr>
          <p:nvPr/>
        </p:nvCxnSpPr>
        <p:spPr>
          <a:xfrm flipH="1">
            <a:off x="8933767" y="5186133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DB45A5D7-91CB-204C-A340-B265AAA3482A}"/>
              </a:ext>
            </a:extLst>
          </p:cNvPr>
          <p:cNvSpPr/>
          <p:nvPr/>
        </p:nvSpPr>
        <p:spPr>
          <a:xfrm>
            <a:off x="9159445" y="3616604"/>
            <a:ext cx="23628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ytTM-SpoIVFB dimer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C112A1D-8ADD-B74C-9F34-D182455DA6B6}"/>
              </a:ext>
            </a:extLst>
          </p:cNvPr>
          <p:cNvCxnSpPr>
            <a:cxnSpLocks/>
          </p:cNvCxnSpPr>
          <p:nvPr/>
        </p:nvCxnSpPr>
        <p:spPr>
          <a:xfrm flipH="1">
            <a:off x="8939267" y="3802672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ECB1A0D-6AAD-FD49-AEFF-54C7A587AF7B}"/>
              </a:ext>
            </a:extLst>
          </p:cNvPr>
          <p:cNvSpPr txBox="1"/>
          <p:nvPr/>
        </p:nvSpPr>
        <p:spPr>
          <a:xfrm>
            <a:off x="9159445" y="4996167"/>
            <a:ext cx="2362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tTM-SpoIVFB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F5E592F-7703-9543-8688-7E0D9A4618EC}"/>
              </a:ext>
            </a:extLst>
          </p:cNvPr>
          <p:cNvSpPr txBox="1"/>
          <p:nvPr/>
        </p:nvSpPr>
        <p:spPr>
          <a:xfrm>
            <a:off x="6789411" y="598275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27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8CC2547-E49E-4148-875D-BB859C397DDA}"/>
              </a:ext>
            </a:extLst>
          </p:cNvPr>
          <p:cNvSpPr txBox="1"/>
          <p:nvPr/>
        </p:nvSpPr>
        <p:spPr>
          <a:xfrm>
            <a:off x="5517216" y="5982752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lasmid#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6E6BF85E-FDD5-224D-911F-94BFEEF1BC2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4509"/>
          <a:stretch/>
        </p:blipFill>
        <p:spPr>
          <a:xfrm>
            <a:off x="4205970" y="2134652"/>
            <a:ext cx="1130300" cy="369886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851FEA52-97B8-7741-B897-685E09A2764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4508" b="1"/>
          <a:stretch/>
        </p:blipFill>
        <p:spPr>
          <a:xfrm>
            <a:off x="5429078" y="2134652"/>
            <a:ext cx="1143000" cy="369886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DEE21152-E7B5-6A45-90C8-2FC371628A7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7104"/>
          <a:stretch/>
        </p:blipFill>
        <p:spPr>
          <a:xfrm>
            <a:off x="6629999" y="2134652"/>
            <a:ext cx="1130300" cy="370451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AE3FA48B-FD68-7947-9B51-376443A7D28B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7246"/>
          <a:stretch/>
        </p:blipFill>
        <p:spPr>
          <a:xfrm>
            <a:off x="7826439" y="2134652"/>
            <a:ext cx="1079500" cy="3698868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06737371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F8BD83-931F-E144-B9DE-7C674F6B90B1}"/>
              </a:ext>
            </a:extLst>
          </p:cNvPr>
          <p:cNvSpPr txBox="1"/>
          <p:nvPr/>
        </p:nvSpPr>
        <p:spPr>
          <a:xfrm>
            <a:off x="632494" y="1172736"/>
            <a:ext cx="7360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Set1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25C9830D-339D-2140-B7CD-A7DA8B9FFF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49962960"/>
              </p:ext>
            </p:extLst>
          </p:nvPr>
        </p:nvGraphicFramePr>
        <p:xfrm>
          <a:off x="3746848" y="1425979"/>
          <a:ext cx="6682746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55185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349480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364229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501173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319342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326004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564542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357809">
                  <a:extLst>
                    <a:ext uri="{9D8B030D-6E8A-4147-A177-3AD203B41FA5}">
                      <a16:colId xmlns:a16="http://schemas.microsoft.com/office/drawing/2014/main" val="148875133"/>
                    </a:ext>
                  </a:extLst>
                </a:gridCol>
                <a:gridCol w="294198">
                  <a:extLst>
                    <a:ext uri="{9D8B030D-6E8A-4147-A177-3AD203B41FA5}">
                      <a16:colId xmlns:a16="http://schemas.microsoft.com/office/drawing/2014/main" val="1233904705"/>
                    </a:ext>
                  </a:extLst>
                </a:gridCol>
                <a:gridCol w="500933">
                  <a:extLst>
                    <a:ext uri="{9D8B030D-6E8A-4147-A177-3AD203B41FA5}">
                      <a16:colId xmlns:a16="http://schemas.microsoft.com/office/drawing/2014/main" val="3656884100"/>
                    </a:ext>
                  </a:extLst>
                </a:gridCol>
                <a:gridCol w="373711">
                  <a:extLst>
                    <a:ext uri="{9D8B030D-6E8A-4147-A177-3AD203B41FA5}">
                      <a16:colId xmlns:a16="http://schemas.microsoft.com/office/drawing/2014/main" val="2509758925"/>
                    </a:ext>
                  </a:extLst>
                </a:gridCol>
                <a:gridCol w="373711">
                  <a:extLst>
                    <a:ext uri="{9D8B030D-6E8A-4147-A177-3AD203B41FA5}">
                      <a16:colId xmlns:a16="http://schemas.microsoft.com/office/drawing/2014/main" val="1113358615"/>
                    </a:ext>
                  </a:extLst>
                </a:gridCol>
                <a:gridCol w="301536">
                  <a:extLst>
                    <a:ext uri="{9D8B030D-6E8A-4147-A177-3AD203B41FA5}">
                      <a16:colId xmlns:a16="http://schemas.microsoft.com/office/drawing/2014/main" val="2422224856"/>
                    </a:ext>
                  </a:extLst>
                </a:gridCol>
                <a:gridCol w="290945">
                  <a:extLst>
                    <a:ext uri="{9D8B030D-6E8A-4147-A177-3AD203B41FA5}">
                      <a16:colId xmlns:a16="http://schemas.microsoft.com/office/drawing/2014/main" val="1253338770"/>
                    </a:ext>
                  </a:extLst>
                </a:gridCol>
                <a:gridCol w="346364">
                  <a:extLst>
                    <a:ext uri="{9D8B030D-6E8A-4147-A177-3AD203B41FA5}">
                      <a16:colId xmlns:a16="http://schemas.microsoft.com/office/drawing/2014/main" val="2419459170"/>
                    </a:ext>
                  </a:extLst>
                </a:gridCol>
                <a:gridCol w="863584">
                  <a:extLst>
                    <a:ext uri="{9D8B030D-6E8A-4147-A177-3AD203B41FA5}">
                      <a16:colId xmlns:a16="http://schemas.microsoft.com/office/drawing/2014/main" val="405931063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800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r>
                        <a:rPr lang="en-US" sz="1800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83DE2251-F7E1-3E42-B923-8EB624AE6126}"/>
              </a:ext>
            </a:extLst>
          </p:cNvPr>
          <p:cNvSpPr/>
          <p:nvPr/>
        </p:nvSpPr>
        <p:spPr>
          <a:xfrm>
            <a:off x="5851395" y="485303"/>
            <a:ext cx="16208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/>
              <a:t>BofA + SpoIVFA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0B1C1C5-BFF8-FF4D-8A0E-24B06406C54B}"/>
              </a:ext>
            </a:extLst>
          </p:cNvPr>
          <p:cNvCxnSpPr>
            <a:cxnSpLocks/>
          </p:cNvCxnSpPr>
          <p:nvPr/>
        </p:nvCxnSpPr>
        <p:spPr>
          <a:xfrm>
            <a:off x="4212928" y="883815"/>
            <a:ext cx="474655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8C9592F-49D7-0844-99C2-8DB7C7D943FF}"/>
              </a:ext>
            </a:extLst>
          </p:cNvPr>
          <p:cNvSpPr txBox="1"/>
          <p:nvPr/>
        </p:nvSpPr>
        <p:spPr>
          <a:xfrm>
            <a:off x="5248722" y="829418"/>
            <a:ext cx="29600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ngle-</a:t>
            </a:r>
            <a:r>
              <a:rPr lang="en-US" dirty="0" err="1"/>
              <a:t>Cys</a:t>
            </a:r>
            <a:r>
              <a:rPr lang="en-US" dirty="0"/>
              <a:t> 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 L41C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737BF3F-6EE7-7A48-85B4-D3C35E84D4BD}"/>
              </a:ext>
            </a:extLst>
          </p:cNvPr>
          <p:cNvCxnSpPr>
            <a:cxnSpLocks/>
          </p:cNvCxnSpPr>
          <p:nvPr/>
        </p:nvCxnSpPr>
        <p:spPr>
          <a:xfrm>
            <a:off x="4187369" y="1153963"/>
            <a:ext cx="477211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DADAD4B-A451-BF44-9398-55F086826971}"/>
              </a:ext>
            </a:extLst>
          </p:cNvPr>
          <p:cNvSpPr txBox="1"/>
          <p:nvPr/>
        </p:nvSpPr>
        <p:spPr>
          <a:xfrm>
            <a:off x="4393986" y="1148029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5 min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FE3AA2A-12E4-264D-A90B-64D156CF03CF}"/>
              </a:ext>
            </a:extLst>
          </p:cNvPr>
          <p:cNvCxnSpPr>
            <a:cxnSpLocks/>
          </p:cNvCxnSpPr>
          <p:nvPr/>
        </p:nvCxnSpPr>
        <p:spPr>
          <a:xfrm>
            <a:off x="5362670" y="1160379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A92A573A-4C4F-D440-AC61-E15E2828EC10}"/>
              </a:ext>
            </a:extLst>
          </p:cNvPr>
          <p:cNvCxnSpPr>
            <a:cxnSpLocks/>
          </p:cNvCxnSpPr>
          <p:nvPr/>
        </p:nvCxnSpPr>
        <p:spPr>
          <a:xfrm>
            <a:off x="6545772" y="1179142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DC9ABD0A-8C17-B94D-A3A8-C1A0FC5FA95A}"/>
              </a:ext>
            </a:extLst>
          </p:cNvPr>
          <p:cNvCxnSpPr>
            <a:cxnSpLocks/>
          </p:cNvCxnSpPr>
          <p:nvPr/>
        </p:nvCxnSpPr>
        <p:spPr>
          <a:xfrm>
            <a:off x="7755180" y="1153217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4AE5154D-8589-134C-9585-E38585188821}"/>
              </a:ext>
            </a:extLst>
          </p:cNvPr>
          <p:cNvSpPr txBox="1"/>
          <p:nvPr/>
        </p:nvSpPr>
        <p:spPr>
          <a:xfrm>
            <a:off x="5573683" y="1148029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0 min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0DC14FA-5251-6E41-90A4-35C6A953FEE7}"/>
              </a:ext>
            </a:extLst>
          </p:cNvPr>
          <p:cNvSpPr txBox="1"/>
          <p:nvPr/>
        </p:nvSpPr>
        <p:spPr>
          <a:xfrm>
            <a:off x="6814467" y="1155980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5 min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7618933-C90E-E54D-8F81-C272538A86F3}"/>
              </a:ext>
            </a:extLst>
          </p:cNvPr>
          <p:cNvSpPr txBox="1"/>
          <p:nvPr/>
        </p:nvSpPr>
        <p:spPr>
          <a:xfrm>
            <a:off x="7992204" y="1164785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0 min</a:t>
            </a: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1CE3BB52-3627-0E44-AE04-A9864AACB996}"/>
              </a:ext>
            </a:extLst>
          </p:cNvPr>
          <p:cNvSpPr/>
          <p:nvPr/>
        </p:nvSpPr>
        <p:spPr>
          <a:xfrm>
            <a:off x="3336940" y="3689370"/>
            <a:ext cx="796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</a:t>
            </a:r>
            <a:r>
              <a:rPr lang="en-US" dirty="0">
                <a:solidFill>
                  <a:prstClr val="black"/>
                </a:solidFill>
                <a:cs typeface="Arial" panose="020B0604020202020204" pitchFamily="34" charset="0"/>
              </a:rPr>
              <a:t>FLAG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EFB319C-01FB-CF45-B370-A688D5811BFC}"/>
              </a:ext>
            </a:extLst>
          </p:cNvPr>
          <p:cNvSpPr txBox="1"/>
          <p:nvPr/>
        </p:nvSpPr>
        <p:spPr>
          <a:xfrm>
            <a:off x="9199201" y="4329093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2D0DA33-455E-C74C-A4FE-3F9B5D705F35}"/>
              </a:ext>
            </a:extLst>
          </p:cNvPr>
          <p:cNvCxnSpPr>
            <a:cxnSpLocks/>
          </p:cNvCxnSpPr>
          <p:nvPr/>
        </p:nvCxnSpPr>
        <p:spPr>
          <a:xfrm flipH="1">
            <a:off x="8966729" y="4524522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3C37B689-6B36-1740-81D0-715391613210}"/>
              </a:ext>
            </a:extLst>
          </p:cNvPr>
          <p:cNvCxnSpPr>
            <a:cxnSpLocks/>
          </p:cNvCxnSpPr>
          <p:nvPr/>
        </p:nvCxnSpPr>
        <p:spPr>
          <a:xfrm flipH="1">
            <a:off x="8973523" y="5238385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DB45A5D7-91CB-204C-A340-B265AAA3482A}"/>
              </a:ext>
            </a:extLst>
          </p:cNvPr>
          <p:cNvSpPr/>
          <p:nvPr/>
        </p:nvSpPr>
        <p:spPr>
          <a:xfrm>
            <a:off x="9199201" y="3773360"/>
            <a:ext cx="23628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ytTM-SpoIVFB dimer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C112A1D-8ADD-B74C-9F34-D182455DA6B6}"/>
              </a:ext>
            </a:extLst>
          </p:cNvPr>
          <p:cNvCxnSpPr>
            <a:cxnSpLocks/>
          </p:cNvCxnSpPr>
          <p:nvPr/>
        </p:nvCxnSpPr>
        <p:spPr>
          <a:xfrm flipH="1">
            <a:off x="8979023" y="3959428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ECB1A0D-6AAD-FD49-AEFF-54C7A587AF7B}"/>
              </a:ext>
            </a:extLst>
          </p:cNvPr>
          <p:cNvSpPr txBox="1"/>
          <p:nvPr/>
        </p:nvSpPr>
        <p:spPr>
          <a:xfrm>
            <a:off x="9199201" y="5048419"/>
            <a:ext cx="2362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tTM-SpoIVFB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F5E592F-7703-9543-8688-7E0D9A4618EC}"/>
              </a:ext>
            </a:extLst>
          </p:cNvPr>
          <p:cNvSpPr txBox="1"/>
          <p:nvPr/>
        </p:nvSpPr>
        <p:spPr>
          <a:xfrm>
            <a:off x="6789411" y="598275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45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8CC2547-E49E-4148-875D-BB859C397DDA}"/>
              </a:ext>
            </a:extLst>
          </p:cNvPr>
          <p:cNvSpPr txBox="1"/>
          <p:nvPr/>
        </p:nvSpPr>
        <p:spPr>
          <a:xfrm>
            <a:off x="5517216" y="5982752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lasmid#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39225B0F-1581-E84C-B71F-CC428EE5A82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6651"/>
          <a:stretch/>
        </p:blipFill>
        <p:spPr>
          <a:xfrm>
            <a:off x="4262211" y="2134652"/>
            <a:ext cx="1066800" cy="369886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F3DA32B0-553D-0049-8CE5-79368D9258F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6651"/>
          <a:stretch/>
        </p:blipFill>
        <p:spPr>
          <a:xfrm>
            <a:off x="5421145" y="2134651"/>
            <a:ext cx="1143000" cy="369886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E6E24F5F-523B-C446-A414-2EC2E444A58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5820"/>
          <a:stretch/>
        </p:blipFill>
        <p:spPr>
          <a:xfrm>
            <a:off x="6650169" y="2134650"/>
            <a:ext cx="1079500" cy="370788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399F068-1A87-F749-B3A9-24569A9EDA55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5820"/>
          <a:stretch/>
        </p:blipFill>
        <p:spPr>
          <a:xfrm>
            <a:off x="7815916" y="2134650"/>
            <a:ext cx="1130300" cy="3707886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92939476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F8BD83-931F-E144-B9DE-7C674F6B90B1}"/>
              </a:ext>
            </a:extLst>
          </p:cNvPr>
          <p:cNvSpPr txBox="1"/>
          <p:nvPr/>
        </p:nvSpPr>
        <p:spPr>
          <a:xfrm>
            <a:off x="632494" y="1172736"/>
            <a:ext cx="7360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Set2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25C9830D-339D-2140-B7CD-A7DA8B9FFF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72551482"/>
              </p:ext>
            </p:extLst>
          </p:nvPr>
        </p:nvGraphicFramePr>
        <p:xfrm>
          <a:off x="3730945" y="1425979"/>
          <a:ext cx="6682746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55185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304589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331138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485030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333955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413468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543378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323314">
                  <a:extLst>
                    <a:ext uri="{9D8B030D-6E8A-4147-A177-3AD203B41FA5}">
                      <a16:colId xmlns:a16="http://schemas.microsoft.com/office/drawing/2014/main" val="148875133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1233904705"/>
                    </a:ext>
                  </a:extLst>
                </a:gridCol>
                <a:gridCol w="508883">
                  <a:extLst>
                    <a:ext uri="{9D8B030D-6E8A-4147-A177-3AD203B41FA5}">
                      <a16:colId xmlns:a16="http://schemas.microsoft.com/office/drawing/2014/main" val="3656884100"/>
                    </a:ext>
                  </a:extLst>
                </a:gridCol>
                <a:gridCol w="278296">
                  <a:extLst>
                    <a:ext uri="{9D8B030D-6E8A-4147-A177-3AD203B41FA5}">
                      <a16:colId xmlns:a16="http://schemas.microsoft.com/office/drawing/2014/main" val="2509758925"/>
                    </a:ext>
                  </a:extLst>
                </a:gridCol>
                <a:gridCol w="349857">
                  <a:extLst>
                    <a:ext uri="{9D8B030D-6E8A-4147-A177-3AD203B41FA5}">
                      <a16:colId xmlns:a16="http://schemas.microsoft.com/office/drawing/2014/main" val="1113358615"/>
                    </a:ext>
                  </a:extLst>
                </a:gridCol>
                <a:gridCol w="389000">
                  <a:extLst>
                    <a:ext uri="{9D8B030D-6E8A-4147-A177-3AD203B41FA5}">
                      <a16:colId xmlns:a16="http://schemas.microsoft.com/office/drawing/2014/main" val="2422224856"/>
                    </a:ext>
                  </a:extLst>
                </a:gridCol>
                <a:gridCol w="290945">
                  <a:extLst>
                    <a:ext uri="{9D8B030D-6E8A-4147-A177-3AD203B41FA5}">
                      <a16:colId xmlns:a16="http://schemas.microsoft.com/office/drawing/2014/main" val="1253338770"/>
                    </a:ext>
                  </a:extLst>
                </a:gridCol>
                <a:gridCol w="346364">
                  <a:extLst>
                    <a:ext uri="{9D8B030D-6E8A-4147-A177-3AD203B41FA5}">
                      <a16:colId xmlns:a16="http://schemas.microsoft.com/office/drawing/2014/main" val="2419459170"/>
                    </a:ext>
                  </a:extLst>
                </a:gridCol>
                <a:gridCol w="863584">
                  <a:extLst>
                    <a:ext uri="{9D8B030D-6E8A-4147-A177-3AD203B41FA5}">
                      <a16:colId xmlns:a16="http://schemas.microsoft.com/office/drawing/2014/main" val="405931063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800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r>
                        <a:rPr lang="en-US" sz="1800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83DE2251-F7E1-3E42-B923-8EB624AE6126}"/>
              </a:ext>
            </a:extLst>
          </p:cNvPr>
          <p:cNvSpPr/>
          <p:nvPr/>
        </p:nvSpPr>
        <p:spPr>
          <a:xfrm>
            <a:off x="5851395" y="485303"/>
            <a:ext cx="16208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/>
              <a:t>BofA + SpoIVFA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0B1C1C5-BFF8-FF4D-8A0E-24B06406C54B}"/>
              </a:ext>
            </a:extLst>
          </p:cNvPr>
          <p:cNvCxnSpPr>
            <a:cxnSpLocks/>
          </p:cNvCxnSpPr>
          <p:nvPr/>
        </p:nvCxnSpPr>
        <p:spPr>
          <a:xfrm>
            <a:off x="4212928" y="883815"/>
            <a:ext cx="474655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8C9592F-49D7-0844-99C2-8DB7C7D943FF}"/>
              </a:ext>
            </a:extLst>
          </p:cNvPr>
          <p:cNvSpPr txBox="1"/>
          <p:nvPr/>
        </p:nvSpPr>
        <p:spPr>
          <a:xfrm>
            <a:off x="5248722" y="829418"/>
            <a:ext cx="29600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ngle-</a:t>
            </a:r>
            <a:r>
              <a:rPr lang="en-US" dirty="0" err="1"/>
              <a:t>Cys</a:t>
            </a:r>
            <a:r>
              <a:rPr lang="en-US" dirty="0"/>
              <a:t> 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 L41C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737BF3F-6EE7-7A48-85B4-D3C35E84D4BD}"/>
              </a:ext>
            </a:extLst>
          </p:cNvPr>
          <p:cNvCxnSpPr>
            <a:cxnSpLocks/>
          </p:cNvCxnSpPr>
          <p:nvPr/>
        </p:nvCxnSpPr>
        <p:spPr>
          <a:xfrm>
            <a:off x="4187369" y="1153963"/>
            <a:ext cx="477211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DADAD4B-A451-BF44-9398-55F086826971}"/>
              </a:ext>
            </a:extLst>
          </p:cNvPr>
          <p:cNvSpPr txBox="1"/>
          <p:nvPr/>
        </p:nvSpPr>
        <p:spPr>
          <a:xfrm>
            <a:off x="4346281" y="1148029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5 min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FE3AA2A-12E4-264D-A90B-64D156CF03CF}"/>
              </a:ext>
            </a:extLst>
          </p:cNvPr>
          <p:cNvCxnSpPr>
            <a:cxnSpLocks/>
          </p:cNvCxnSpPr>
          <p:nvPr/>
        </p:nvCxnSpPr>
        <p:spPr>
          <a:xfrm>
            <a:off x="5362670" y="1160379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A92A573A-4C4F-D440-AC61-E15E2828EC10}"/>
              </a:ext>
            </a:extLst>
          </p:cNvPr>
          <p:cNvCxnSpPr>
            <a:cxnSpLocks/>
          </p:cNvCxnSpPr>
          <p:nvPr/>
        </p:nvCxnSpPr>
        <p:spPr>
          <a:xfrm>
            <a:off x="6545772" y="1179142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DC9ABD0A-8C17-B94D-A3A8-C1A0FC5FA95A}"/>
              </a:ext>
            </a:extLst>
          </p:cNvPr>
          <p:cNvCxnSpPr>
            <a:cxnSpLocks/>
          </p:cNvCxnSpPr>
          <p:nvPr/>
        </p:nvCxnSpPr>
        <p:spPr>
          <a:xfrm>
            <a:off x="7755180" y="1153217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4AE5154D-8589-134C-9585-E38585188821}"/>
              </a:ext>
            </a:extLst>
          </p:cNvPr>
          <p:cNvSpPr txBox="1"/>
          <p:nvPr/>
        </p:nvSpPr>
        <p:spPr>
          <a:xfrm>
            <a:off x="5486222" y="1148029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0 min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0DC14FA-5251-6E41-90A4-35C6A953FEE7}"/>
              </a:ext>
            </a:extLst>
          </p:cNvPr>
          <p:cNvSpPr txBox="1"/>
          <p:nvPr/>
        </p:nvSpPr>
        <p:spPr>
          <a:xfrm>
            <a:off x="6759918" y="1161443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5 min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7618933-C90E-E54D-8F81-C272538A86F3}"/>
              </a:ext>
            </a:extLst>
          </p:cNvPr>
          <p:cNvSpPr txBox="1"/>
          <p:nvPr/>
        </p:nvSpPr>
        <p:spPr>
          <a:xfrm>
            <a:off x="7928596" y="1172736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0 min</a:t>
            </a: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1CE3BB52-3627-0E44-AE04-A9864AACB996}"/>
              </a:ext>
            </a:extLst>
          </p:cNvPr>
          <p:cNvSpPr/>
          <p:nvPr/>
        </p:nvSpPr>
        <p:spPr>
          <a:xfrm>
            <a:off x="3336940" y="3689370"/>
            <a:ext cx="796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</a:t>
            </a:r>
            <a:r>
              <a:rPr lang="en-US" dirty="0">
                <a:solidFill>
                  <a:prstClr val="black"/>
                </a:solidFill>
                <a:cs typeface="Arial" panose="020B0604020202020204" pitchFamily="34" charset="0"/>
              </a:rPr>
              <a:t>FLAG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EFB319C-01FB-CF45-B370-A688D5811BFC}"/>
              </a:ext>
            </a:extLst>
          </p:cNvPr>
          <p:cNvSpPr txBox="1"/>
          <p:nvPr/>
        </p:nvSpPr>
        <p:spPr>
          <a:xfrm>
            <a:off x="9238956" y="4305240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2D0DA33-455E-C74C-A4FE-3F9B5D705F35}"/>
              </a:ext>
            </a:extLst>
          </p:cNvPr>
          <p:cNvCxnSpPr>
            <a:cxnSpLocks/>
          </p:cNvCxnSpPr>
          <p:nvPr/>
        </p:nvCxnSpPr>
        <p:spPr>
          <a:xfrm flipH="1">
            <a:off x="9006484" y="4500669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3C37B689-6B36-1740-81D0-715391613210}"/>
              </a:ext>
            </a:extLst>
          </p:cNvPr>
          <p:cNvCxnSpPr>
            <a:cxnSpLocks/>
          </p:cNvCxnSpPr>
          <p:nvPr/>
        </p:nvCxnSpPr>
        <p:spPr>
          <a:xfrm flipH="1">
            <a:off x="9013278" y="5214532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DB45A5D7-91CB-204C-A340-B265AAA3482A}"/>
              </a:ext>
            </a:extLst>
          </p:cNvPr>
          <p:cNvSpPr/>
          <p:nvPr/>
        </p:nvSpPr>
        <p:spPr>
          <a:xfrm>
            <a:off x="9238956" y="3684192"/>
            <a:ext cx="23628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ytTM-SpoIVFB dimer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C112A1D-8ADD-B74C-9F34-D182455DA6B6}"/>
              </a:ext>
            </a:extLst>
          </p:cNvPr>
          <p:cNvCxnSpPr>
            <a:cxnSpLocks/>
          </p:cNvCxnSpPr>
          <p:nvPr/>
        </p:nvCxnSpPr>
        <p:spPr>
          <a:xfrm flipH="1">
            <a:off x="9018778" y="3870260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ECB1A0D-6AAD-FD49-AEFF-54C7A587AF7B}"/>
              </a:ext>
            </a:extLst>
          </p:cNvPr>
          <p:cNvSpPr txBox="1"/>
          <p:nvPr/>
        </p:nvSpPr>
        <p:spPr>
          <a:xfrm>
            <a:off x="9238956" y="5024566"/>
            <a:ext cx="2362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tTM-SpoIVFB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F5E592F-7703-9543-8688-7E0D9A4618EC}"/>
              </a:ext>
            </a:extLst>
          </p:cNvPr>
          <p:cNvSpPr txBox="1"/>
          <p:nvPr/>
        </p:nvSpPr>
        <p:spPr>
          <a:xfrm>
            <a:off x="6789411" y="598275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45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8CC2547-E49E-4148-875D-BB859C397DDA}"/>
              </a:ext>
            </a:extLst>
          </p:cNvPr>
          <p:cNvSpPr txBox="1"/>
          <p:nvPr/>
        </p:nvSpPr>
        <p:spPr>
          <a:xfrm>
            <a:off x="5517216" y="5982752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lasmid#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272CFBC-28F2-3444-BB28-46CC0583FDA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8522"/>
          <a:stretch/>
        </p:blipFill>
        <p:spPr>
          <a:xfrm>
            <a:off x="4205614" y="2141814"/>
            <a:ext cx="1117600" cy="370602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45BD7B55-ADC7-6C45-8FE4-9030C0FBA51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8346"/>
          <a:stretch/>
        </p:blipFill>
        <p:spPr>
          <a:xfrm>
            <a:off x="5405497" y="2134652"/>
            <a:ext cx="1143000" cy="371318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85F550DD-E3E6-AF49-B054-6535AB491DA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1642"/>
          <a:stretch/>
        </p:blipFill>
        <p:spPr>
          <a:xfrm>
            <a:off x="6616439" y="2134652"/>
            <a:ext cx="1117600" cy="369748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AC182F2E-3CBB-614C-8108-B580A72639EE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1642"/>
          <a:stretch/>
        </p:blipFill>
        <p:spPr>
          <a:xfrm>
            <a:off x="7801981" y="2134652"/>
            <a:ext cx="1168400" cy="3697486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4128009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2C5B878757C6144B104C5E4029E0BB6" ma:contentTypeVersion="14" ma:contentTypeDescription="Create a new document." ma:contentTypeScope="" ma:versionID="9f688f900531a4236b6da98bf3cb268f">
  <xsd:schema xmlns:xsd="http://www.w3.org/2001/XMLSchema" xmlns:xs="http://www.w3.org/2001/XMLSchema" xmlns:p="http://schemas.microsoft.com/office/2006/metadata/properties" xmlns:ns3="0b01a07b-8d13-4cb5-9d22-64822278069e" xmlns:ns4="198a9f0d-948e-4f5a-af70-f6d2f30972cd" targetNamespace="http://schemas.microsoft.com/office/2006/metadata/properties" ma:root="true" ma:fieldsID="c04d3e0e4baedd5a0de5ec8817e1430b" ns3:_="" ns4:_="">
    <xsd:import namespace="0b01a07b-8d13-4cb5-9d22-64822278069e"/>
    <xsd:import namespace="198a9f0d-948e-4f5a-af70-f6d2f30972cd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b01a07b-8d13-4cb5-9d22-64822278069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98a9f0d-948e-4f5a-af70-f6d2f30972cd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0D9044F7-96F9-4AEE-A12C-4D086F740E2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b01a07b-8d13-4cb5-9d22-64822278069e"/>
    <ds:schemaRef ds:uri="198a9f0d-948e-4f5a-af70-f6d2f30972c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174F4B81-A981-4A4F-A287-0DD77B00DD77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0FA6A299-4CCB-48F4-BFAF-1B284B704E41}">
  <ds:schemaRefs>
    <ds:schemaRef ds:uri="http://purl.org/dc/terms/"/>
    <ds:schemaRef ds:uri="http://www.w3.org/XML/1998/namespace"/>
    <ds:schemaRef ds:uri="http://schemas.microsoft.com/office/infopath/2007/PartnerControls"/>
    <ds:schemaRef ds:uri="http://schemas.microsoft.com/office/2006/documentManagement/types"/>
    <ds:schemaRef ds:uri="198a9f0d-948e-4f5a-af70-f6d2f30972cd"/>
    <ds:schemaRef ds:uri="http://purl.org/dc/dcmitype/"/>
    <ds:schemaRef ds:uri="http://purl.org/dc/elements/1.1/"/>
    <ds:schemaRef ds:uri="http://schemas.openxmlformats.org/package/2006/metadata/core-properties"/>
    <ds:schemaRef ds:uri="0b01a07b-8d13-4cb5-9d22-64822278069e"/>
    <ds:schemaRef ds:uri="http://schemas.microsoft.com/office/2006/metadata/propertie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38</TotalTime>
  <Words>400</Words>
  <Application>Microsoft Office PowerPoint</Application>
  <PresentationFormat>Widescreen</PresentationFormat>
  <Paragraphs>312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Courier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Lee Kroos</cp:lastModifiedBy>
  <cp:revision>28</cp:revision>
  <dcterms:created xsi:type="dcterms:W3CDTF">2021-10-05T00:44:03Z</dcterms:created>
  <dcterms:modified xsi:type="dcterms:W3CDTF">2021-10-22T15:32:1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2C5B878757C6144B104C5E4029E0BB6</vt:lpwstr>
  </property>
</Properties>
</file>